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25" r:id="rId2"/>
    <p:sldId id="321" r:id="rId3"/>
    <p:sldId id="320" r:id="rId4"/>
    <p:sldId id="323" r:id="rId5"/>
    <p:sldId id="322" r:id="rId6"/>
  </p:sldIdLst>
  <p:sldSz cx="12801600" cy="1463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3C25549-FEA1-01FF-B936-DE4DB75E5DEF}" v="17" dt="2021-07-16T12:15:14.161"/>
    <p1510:client id="{3C62F38E-385A-41A1-DC79-CF69F64B677C}" v="47" dt="2021-07-16T11:59:09.489"/>
    <p1510:client id="{620A622E-0A9D-4B00-A477-F41DAD63384B}" v="86" dt="2021-07-18T06:55:16.813"/>
    <p1510:client id="{C204F2BB-0832-3053-46B3-EF85AD6BBF7D}" v="2" dt="2021-07-16T12:03:06.57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slideViewPr>
    <p:cSldViewPr snapToGrid="0">
      <p:cViewPr>
        <p:scale>
          <a:sx n="1" d="2"/>
          <a:sy n="1" d="2"/>
        </p:scale>
        <p:origin x="0" y="0"/>
      </p:cViewPr>
      <p:guideLst/>
    </p:cSldViewPr>
  </p:slide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ida Habib Abdul Karim" userId="S::ah31@aub.edu.lb::1255dc41-9f64-4698-8d06-c976256b7115" providerId="AD" clId="Web-{620A622E-0A9D-4B00-A477-F41DAD63384B}"/>
    <pc:docChg chg="modSld">
      <pc:chgData name="Aida Habib Abdul Karim" userId="S::ah31@aub.edu.lb::1255dc41-9f64-4698-8d06-c976256b7115" providerId="AD" clId="Web-{620A622E-0A9D-4B00-A477-F41DAD63384B}" dt="2021-07-18T06:55:16.813" v="52"/>
      <pc:docMkLst>
        <pc:docMk/>
      </pc:docMkLst>
      <pc:sldChg chg="modSp">
        <pc:chgData name="Aida Habib Abdul Karim" userId="S::ah31@aub.edu.lb::1255dc41-9f64-4698-8d06-c976256b7115" providerId="AD" clId="Web-{620A622E-0A9D-4B00-A477-F41DAD63384B}" dt="2021-07-18T06:52:33.371" v="46" actId="20577"/>
        <pc:sldMkLst>
          <pc:docMk/>
          <pc:sldMk cId="2958072592" sldId="320"/>
        </pc:sldMkLst>
        <pc:spChg chg="mod">
          <ac:chgData name="Aida Habib Abdul Karim" userId="S::ah31@aub.edu.lb::1255dc41-9f64-4698-8d06-c976256b7115" providerId="AD" clId="Web-{620A622E-0A9D-4B00-A477-F41DAD63384B}" dt="2021-07-18T06:52:33.371" v="46" actId="20577"/>
          <ac:spMkLst>
            <pc:docMk/>
            <pc:sldMk cId="2958072592" sldId="320"/>
            <ac:spMk id="36" creationId="{B097105A-FA9E-4678-9E84-7EB0215E15DC}"/>
          </ac:spMkLst>
        </pc:spChg>
      </pc:sldChg>
      <pc:sldChg chg="modSp">
        <pc:chgData name="Aida Habib Abdul Karim" userId="S::ah31@aub.edu.lb::1255dc41-9f64-4698-8d06-c976256b7115" providerId="AD" clId="Web-{620A622E-0A9D-4B00-A477-F41DAD63384B}" dt="2021-07-18T06:54:02.717" v="49" actId="20577"/>
        <pc:sldMkLst>
          <pc:docMk/>
          <pc:sldMk cId="3162967167" sldId="321"/>
        </pc:sldMkLst>
        <pc:spChg chg="mod">
          <ac:chgData name="Aida Habib Abdul Karim" userId="S::ah31@aub.edu.lb::1255dc41-9f64-4698-8d06-c976256b7115" providerId="AD" clId="Web-{620A622E-0A9D-4B00-A477-F41DAD63384B}" dt="2021-07-18T06:54:02.717" v="49" actId="20577"/>
          <ac:spMkLst>
            <pc:docMk/>
            <pc:sldMk cId="3162967167" sldId="321"/>
            <ac:spMk id="13" creationId="{1EE6B46D-C0DD-4894-8663-761BEE7E5BEB}"/>
          </ac:spMkLst>
        </pc:spChg>
      </pc:sldChg>
      <pc:sldChg chg="modSp">
        <pc:chgData name="Aida Habib Abdul Karim" userId="S::ah31@aub.edu.lb::1255dc41-9f64-4698-8d06-c976256b7115" providerId="AD" clId="Web-{620A622E-0A9D-4B00-A477-F41DAD63384B}" dt="2021-07-18T06:55:16.813" v="52"/>
        <pc:sldMkLst>
          <pc:docMk/>
          <pc:sldMk cId="3182721296" sldId="322"/>
        </pc:sldMkLst>
        <pc:spChg chg="mod">
          <ac:chgData name="Aida Habib Abdul Karim" userId="S::ah31@aub.edu.lb::1255dc41-9f64-4698-8d06-c976256b7115" providerId="AD" clId="Web-{620A622E-0A9D-4B00-A477-F41DAD63384B}" dt="2021-07-18T06:55:16.813" v="52"/>
          <ac:spMkLst>
            <pc:docMk/>
            <pc:sldMk cId="3182721296" sldId="322"/>
            <ac:spMk id="14" creationId="{1E8FE562-63F3-4A4F-A4B2-E24F47D5F0A7}"/>
          </ac:spMkLst>
        </pc:spChg>
      </pc:sldChg>
      <pc:sldChg chg="modSp">
        <pc:chgData name="Aida Habib Abdul Karim" userId="S::ah31@aub.edu.lb::1255dc41-9f64-4698-8d06-c976256b7115" providerId="AD" clId="Web-{620A622E-0A9D-4B00-A477-F41DAD63384B}" dt="2021-07-18T06:54:34.296" v="51"/>
        <pc:sldMkLst>
          <pc:docMk/>
          <pc:sldMk cId="2155063690" sldId="323"/>
        </pc:sldMkLst>
        <pc:spChg chg="mod">
          <ac:chgData name="Aida Habib Abdul Karim" userId="S::ah31@aub.edu.lb::1255dc41-9f64-4698-8d06-c976256b7115" providerId="AD" clId="Web-{620A622E-0A9D-4B00-A477-F41DAD63384B}" dt="2021-07-18T06:54:34.296" v="51"/>
          <ac:spMkLst>
            <pc:docMk/>
            <pc:sldMk cId="2155063690" sldId="323"/>
            <ac:spMk id="3" creationId="{F4D82F7C-C609-47A5-AEDA-0200DABF29E0}"/>
          </ac:spMkLst>
        </pc:spChg>
      </pc:sldChg>
      <pc:sldChg chg="modSp">
        <pc:chgData name="Aida Habib Abdul Karim" userId="S::ah31@aub.edu.lb::1255dc41-9f64-4698-8d06-c976256b7115" providerId="AD" clId="Web-{620A622E-0A9D-4B00-A477-F41DAD63384B}" dt="2021-07-18T06:47:19.317" v="23" actId="20577"/>
        <pc:sldMkLst>
          <pc:docMk/>
          <pc:sldMk cId="2819329662" sldId="325"/>
        </pc:sldMkLst>
        <pc:spChg chg="mod">
          <ac:chgData name="Aida Habib Abdul Karim" userId="S::ah31@aub.edu.lb::1255dc41-9f64-4698-8d06-c976256b7115" providerId="AD" clId="Web-{620A622E-0A9D-4B00-A477-F41DAD63384B}" dt="2021-07-18T06:47:19.317" v="23" actId="20577"/>
          <ac:spMkLst>
            <pc:docMk/>
            <pc:sldMk cId="2819329662" sldId="325"/>
            <ac:spMk id="5" creationId="{B2C79E7B-1E04-4676-9F45-526478E2E5A3}"/>
          </ac:spMkLst>
        </pc:spChg>
      </pc:sldChg>
    </pc:docChg>
  </pc:docChgLst>
  <pc:docChgLst>
    <pc:chgData name="Aida Habib Abdul Karim" userId="S::ah31@aub.edu.lb::1255dc41-9f64-4698-8d06-c976256b7115" providerId="AD" clId="Web-{3C62F38E-385A-41A1-DC79-CF69F64B677C}"/>
    <pc:docChg chg="modSld">
      <pc:chgData name="Aida Habib Abdul Karim" userId="S::ah31@aub.edu.lb::1255dc41-9f64-4698-8d06-c976256b7115" providerId="AD" clId="Web-{3C62F38E-385A-41A1-DC79-CF69F64B677C}" dt="2021-07-16T11:59:08.630" v="23" actId="20577"/>
      <pc:docMkLst>
        <pc:docMk/>
      </pc:docMkLst>
      <pc:sldChg chg="modSp">
        <pc:chgData name="Aida Habib Abdul Karim" userId="S::ah31@aub.edu.lb::1255dc41-9f64-4698-8d06-c976256b7115" providerId="AD" clId="Web-{3C62F38E-385A-41A1-DC79-CF69F64B677C}" dt="2021-07-16T11:59:08.630" v="23" actId="20577"/>
        <pc:sldMkLst>
          <pc:docMk/>
          <pc:sldMk cId="3162967167" sldId="321"/>
        </pc:sldMkLst>
        <pc:spChg chg="mod">
          <ac:chgData name="Aida Habib Abdul Karim" userId="S::ah31@aub.edu.lb::1255dc41-9f64-4698-8d06-c976256b7115" providerId="AD" clId="Web-{3C62F38E-385A-41A1-DC79-CF69F64B677C}" dt="2021-07-16T11:59:08.630" v="23" actId="20577"/>
          <ac:spMkLst>
            <pc:docMk/>
            <pc:sldMk cId="3162967167" sldId="321"/>
            <ac:spMk id="13" creationId="{1EE6B46D-C0DD-4894-8663-761BEE7E5BEB}"/>
          </ac:spMkLst>
        </pc:spChg>
      </pc:sldChg>
      <pc:sldChg chg="delSp">
        <pc:chgData name="Aida Habib Abdul Karim" userId="S::ah31@aub.edu.lb::1255dc41-9f64-4698-8d06-c976256b7115" providerId="AD" clId="Web-{3C62F38E-385A-41A1-DC79-CF69F64B677C}" dt="2021-07-16T11:57:32.518" v="1"/>
        <pc:sldMkLst>
          <pc:docMk/>
          <pc:sldMk cId="2819329662" sldId="325"/>
        </pc:sldMkLst>
        <pc:spChg chg="del">
          <ac:chgData name="Aida Habib Abdul Karim" userId="S::ah31@aub.edu.lb::1255dc41-9f64-4698-8d06-c976256b7115" providerId="AD" clId="Web-{3C62F38E-385A-41A1-DC79-CF69F64B677C}" dt="2021-07-16T11:57:32.518" v="1"/>
          <ac:spMkLst>
            <pc:docMk/>
            <pc:sldMk cId="2819329662" sldId="325"/>
            <ac:spMk id="3" creationId="{6F10F6ED-793B-4480-A452-DBB0C7D53F13}"/>
          </ac:spMkLst>
        </pc:spChg>
        <pc:spChg chg="del">
          <ac:chgData name="Aida Habib Abdul Karim" userId="S::ah31@aub.edu.lb::1255dc41-9f64-4698-8d06-c976256b7115" providerId="AD" clId="Web-{3C62F38E-385A-41A1-DC79-CF69F64B677C}" dt="2021-07-16T11:57:32.330" v="0"/>
          <ac:spMkLst>
            <pc:docMk/>
            <pc:sldMk cId="2819329662" sldId="325"/>
            <ac:spMk id="15" creationId="{11CEC8A9-66EA-446F-8FDF-37A315A5A1AD}"/>
          </ac:spMkLst>
        </pc:spChg>
      </pc:sldChg>
    </pc:docChg>
  </pc:docChgLst>
  <pc:docChgLst>
    <pc:chgData name="Aida Habib Abdul Karim" userId="S::ah31@aub.edu.lb::1255dc41-9f64-4698-8d06-c976256b7115" providerId="AD" clId="Web-{C204F2BB-0832-3053-46B3-EF85AD6BBF7D}"/>
    <pc:docChg chg="modSld">
      <pc:chgData name="Aida Habib Abdul Karim" userId="S::ah31@aub.edu.lb::1255dc41-9f64-4698-8d06-c976256b7115" providerId="AD" clId="Web-{C204F2BB-0832-3053-46B3-EF85AD6BBF7D}" dt="2021-07-16T12:03:06.573" v="0" actId="20577"/>
      <pc:docMkLst>
        <pc:docMk/>
      </pc:docMkLst>
      <pc:sldChg chg="modSp">
        <pc:chgData name="Aida Habib Abdul Karim" userId="S::ah31@aub.edu.lb::1255dc41-9f64-4698-8d06-c976256b7115" providerId="AD" clId="Web-{C204F2BB-0832-3053-46B3-EF85AD6BBF7D}" dt="2021-07-16T12:03:06.573" v="0" actId="20577"/>
        <pc:sldMkLst>
          <pc:docMk/>
          <pc:sldMk cId="3162967167" sldId="321"/>
        </pc:sldMkLst>
        <pc:spChg chg="mod">
          <ac:chgData name="Aida Habib Abdul Karim" userId="S::ah31@aub.edu.lb::1255dc41-9f64-4698-8d06-c976256b7115" providerId="AD" clId="Web-{C204F2BB-0832-3053-46B3-EF85AD6BBF7D}" dt="2021-07-16T12:03:06.573" v="0" actId="20577"/>
          <ac:spMkLst>
            <pc:docMk/>
            <pc:sldMk cId="3162967167" sldId="321"/>
            <ac:spMk id="13" creationId="{1EE6B46D-C0DD-4894-8663-761BEE7E5BEB}"/>
          </ac:spMkLst>
        </pc:spChg>
      </pc:sldChg>
    </pc:docChg>
  </pc:docChgLst>
  <pc:docChgLst>
    <pc:chgData name="Aida Habib Abdul Karim" userId="S::ah31@aub.edu.lb::1255dc41-9f64-4698-8d06-c976256b7115" providerId="AD" clId="Web-{23C25549-FEA1-01FF-B936-DE4DB75E5DEF}"/>
    <pc:docChg chg="modSld">
      <pc:chgData name="Aida Habib Abdul Karim" userId="S::ah31@aub.edu.lb::1255dc41-9f64-4698-8d06-c976256b7115" providerId="AD" clId="Web-{23C25549-FEA1-01FF-B936-DE4DB75E5DEF}" dt="2021-07-16T12:15:12.224" v="6" actId="20577"/>
      <pc:docMkLst>
        <pc:docMk/>
      </pc:docMkLst>
      <pc:sldChg chg="modSp">
        <pc:chgData name="Aida Habib Abdul Karim" userId="S::ah31@aub.edu.lb::1255dc41-9f64-4698-8d06-c976256b7115" providerId="AD" clId="Web-{23C25549-FEA1-01FF-B936-DE4DB75E5DEF}" dt="2021-07-16T12:07:37.091" v="0" actId="20577"/>
        <pc:sldMkLst>
          <pc:docMk/>
          <pc:sldMk cId="2958072592" sldId="320"/>
        </pc:sldMkLst>
        <pc:spChg chg="mod">
          <ac:chgData name="Aida Habib Abdul Karim" userId="S::ah31@aub.edu.lb::1255dc41-9f64-4698-8d06-c976256b7115" providerId="AD" clId="Web-{23C25549-FEA1-01FF-B936-DE4DB75E5DEF}" dt="2021-07-16T12:07:37.091" v="0" actId="20577"/>
          <ac:spMkLst>
            <pc:docMk/>
            <pc:sldMk cId="2958072592" sldId="320"/>
            <ac:spMk id="36" creationId="{B097105A-FA9E-4678-9E84-7EB0215E15DC}"/>
          </ac:spMkLst>
        </pc:spChg>
      </pc:sldChg>
      <pc:sldChg chg="modSp">
        <pc:chgData name="Aida Habib Abdul Karim" userId="S::ah31@aub.edu.lb::1255dc41-9f64-4698-8d06-c976256b7115" providerId="AD" clId="Web-{23C25549-FEA1-01FF-B936-DE4DB75E5DEF}" dt="2021-07-16T12:15:12.224" v="6" actId="20577"/>
        <pc:sldMkLst>
          <pc:docMk/>
          <pc:sldMk cId="3182721296" sldId="322"/>
        </pc:sldMkLst>
        <pc:spChg chg="mod">
          <ac:chgData name="Aida Habib Abdul Karim" userId="S::ah31@aub.edu.lb::1255dc41-9f64-4698-8d06-c976256b7115" providerId="AD" clId="Web-{23C25549-FEA1-01FF-B936-DE4DB75E5DEF}" dt="2021-07-16T12:15:12.224" v="6" actId="20577"/>
          <ac:spMkLst>
            <pc:docMk/>
            <pc:sldMk cId="3182721296" sldId="322"/>
            <ac:spMk id="14" creationId="{1E8FE562-63F3-4A4F-A4B2-E24F47D5F0A7}"/>
          </ac:spMkLst>
        </pc:spChg>
      </pc:sldChg>
      <pc:sldChg chg="modSp">
        <pc:chgData name="Aida Habib Abdul Karim" userId="S::ah31@aub.edu.lb::1255dc41-9f64-4698-8d06-c976256b7115" providerId="AD" clId="Web-{23C25549-FEA1-01FF-B936-DE4DB75E5DEF}" dt="2021-07-16T12:07:41.592" v="1" actId="20577"/>
        <pc:sldMkLst>
          <pc:docMk/>
          <pc:sldMk cId="2155063690" sldId="323"/>
        </pc:sldMkLst>
        <pc:spChg chg="mod">
          <ac:chgData name="Aida Habib Abdul Karim" userId="S::ah31@aub.edu.lb::1255dc41-9f64-4698-8d06-c976256b7115" providerId="AD" clId="Web-{23C25549-FEA1-01FF-B936-DE4DB75E5DEF}" dt="2021-07-16T12:07:41.592" v="1" actId="20577"/>
          <ac:spMkLst>
            <pc:docMk/>
            <pc:sldMk cId="2155063690" sldId="323"/>
            <ac:spMk id="3" creationId="{F4D82F7C-C609-47A5-AEDA-0200DABF29E0}"/>
          </ac:spMkLst>
        </pc:sp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Relationship Id="rId4" Type="http://schemas.openxmlformats.org/officeDocument/2006/relationships/image" Target="../media/image1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2394374"/>
            <a:ext cx="10881360" cy="5093547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7684348"/>
            <a:ext cx="9601200" cy="3532292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7607D-065A-49D1-9F51-F049A5E21E45}" type="datetimeFigureOut">
              <a:rPr lang="en-US" smtClean="0"/>
              <a:t>7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4710F-F054-4EB4-9208-9F2A93110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575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7607D-065A-49D1-9F51-F049A5E21E45}" type="datetimeFigureOut">
              <a:rPr lang="en-US" smtClean="0"/>
              <a:t>7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4710F-F054-4EB4-9208-9F2A93110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681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778933"/>
            <a:ext cx="2760345" cy="123985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778933"/>
            <a:ext cx="8121015" cy="1239858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7607D-065A-49D1-9F51-F049A5E21E45}" type="datetimeFigureOut">
              <a:rPr lang="en-US" smtClean="0"/>
              <a:t>7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4710F-F054-4EB4-9208-9F2A93110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059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7607D-065A-49D1-9F51-F049A5E21E45}" type="datetimeFigureOut">
              <a:rPr lang="en-US" smtClean="0"/>
              <a:t>7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4710F-F054-4EB4-9208-9F2A93110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482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3647444"/>
            <a:ext cx="11041380" cy="6085839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9790858"/>
            <a:ext cx="11041380" cy="3200399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/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7607D-065A-49D1-9F51-F049A5E21E45}" type="datetimeFigureOut">
              <a:rPr lang="en-US" smtClean="0"/>
              <a:t>7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4710F-F054-4EB4-9208-9F2A93110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0534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3894667"/>
            <a:ext cx="5440680" cy="92828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3894667"/>
            <a:ext cx="5440680" cy="92828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7607D-065A-49D1-9F51-F049A5E21E45}" type="datetimeFigureOut">
              <a:rPr lang="en-US" smtClean="0"/>
              <a:t>7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4710F-F054-4EB4-9208-9F2A93110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6243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778936"/>
            <a:ext cx="11041380" cy="2827868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3586481"/>
            <a:ext cx="5415676" cy="1757679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5344160"/>
            <a:ext cx="5415676" cy="78604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3586481"/>
            <a:ext cx="5442347" cy="1757679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5344160"/>
            <a:ext cx="5442347" cy="78604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7607D-065A-49D1-9F51-F049A5E21E45}" type="datetimeFigureOut">
              <a:rPr lang="en-US" smtClean="0"/>
              <a:t>7/1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4710F-F054-4EB4-9208-9F2A93110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8308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7607D-065A-49D1-9F51-F049A5E21E45}" type="datetimeFigureOut">
              <a:rPr lang="en-US" smtClean="0"/>
              <a:t>7/1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4710F-F054-4EB4-9208-9F2A93110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9784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7607D-065A-49D1-9F51-F049A5E21E45}" type="datetimeFigureOut">
              <a:rPr lang="en-US" smtClean="0"/>
              <a:t>7/1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4710F-F054-4EB4-9208-9F2A93110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280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975360"/>
            <a:ext cx="4128849" cy="341376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2106510"/>
            <a:ext cx="6480810" cy="10397067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4389120"/>
            <a:ext cx="4128849" cy="8131388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7607D-065A-49D1-9F51-F049A5E21E45}" type="datetimeFigureOut">
              <a:rPr lang="en-US" smtClean="0"/>
              <a:t>7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4710F-F054-4EB4-9208-9F2A93110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4100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975360"/>
            <a:ext cx="4128849" cy="341376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2106510"/>
            <a:ext cx="6480810" cy="10397067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4389120"/>
            <a:ext cx="4128849" cy="8131388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7607D-065A-49D1-9F51-F049A5E21E45}" type="datetimeFigureOut">
              <a:rPr lang="en-US" smtClean="0"/>
              <a:t>7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4710F-F054-4EB4-9208-9F2A93110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658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778936"/>
            <a:ext cx="11041380" cy="28278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3894667"/>
            <a:ext cx="11041380" cy="928285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13560217"/>
            <a:ext cx="288036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F7607D-065A-49D1-9F51-F049A5E21E45}" type="datetimeFigureOut">
              <a:rPr lang="en-US" smtClean="0"/>
              <a:t>7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13560217"/>
            <a:ext cx="432054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13560217"/>
            <a:ext cx="288036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74710F-F054-4EB4-9208-9F2A93110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547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2.emf"/><Relationship Id="rId4" Type="http://schemas.openxmlformats.org/officeDocument/2006/relationships/image" Target="../media/image9.emf"/><Relationship Id="rId9" Type="http://schemas.openxmlformats.org/officeDocument/2006/relationships/oleObject" Target="../embeddings/oleObject4.bin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53E3448-BCC6-460F-A544-70EB317AD3C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9675641"/>
              </p:ext>
            </p:extLst>
          </p:nvPr>
        </p:nvGraphicFramePr>
        <p:xfrm>
          <a:off x="743185" y="1541549"/>
          <a:ext cx="8195016" cy="6046060"/>
        </p:xfrm>
        <a:graphic>
          <a:graphicData uri="http://schemas.openxmlformats.org/drawingml/2006/table">
            <a:tbl>
              <a:tblPr firstRow="1" firstCol="1" bandRow="1"/>
              <a:tblGrid>
                <a:gridCol w="2632824">
                  <a:extLst>
                    <a:ext uri="{9D8B030D-6E8A-4147-A177-3AD203B41FA5}">
                      <a16:colId xmlns:a16="http://schemas.microsoft.com/office/drawing/2014/main" val="65739781"/>
                    </a:ext>
                  </a:extLst>
                </a:gridCol>
                <a:gridCol w="2838581">
                  <a:extLst>
                    <a:ext uri="{9D8B030D-6E8A-4147-A177-3AD203B41FA5}">
                      <a16:colId xmlns:a16="http://schemas.microsoft.com/office/drawing/2014/main" val="3088839919"/>
                    </a:ext>
                  </a:extLst>
                </a:gridCol>
                <a:gridCol w="2723611">
                  <a:extLst>
                    <a:ext uri="{9D8B030D-6E8A-4147-A177-3AD203B41FA5}">
                      <a16:colId xmlns:a16="http://schemas.microsoft.com/office/drawing/2014/main" val="2274025825"/>
                    </a:ext>
                  </a:extLst>
                </a:gridCol>
              </a:tblGrid>
              <a:tr h="292591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use Gene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nse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tisens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3003561"/>
                  </a:ext>
                </a:extLst>
              </a:tr>
              <a:tr h="397539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S, </a:t>
                      </a:r>
                      <a:r>
                        <a:rPr lang="en-US" sz="1200" i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nfa</a:t>
                      </a:r>
                      <a:r>
                        <a:rPr lang="en-US" sz="1200" i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Il1b, </a:t>
                      </a:r>
                      <a:r>
                        <a:rPr lang="en-US" sz="1200" i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gre</a:t>
                      </a:r>
                      <a:r>
                        <a:rPr lang="en-US" sz="1200" i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Ly6c, Ly6g, Il6, Ccl2, Ccl3, Mmp2, Mmp9, Timp1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scribed previously (Habib et al., 2019)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006435"/>
                  </a:ext>
                </a:extLst>
              </a:tr>
              <a:tr h="292591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lkb1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28939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CCCATGGATATTTTCCAGCA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AGATGGTGCGACACACAAAG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7957266"/>
                  </a:ext>
                </a:extLst>
              </a:tr>
              <a:tr h="292591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ng1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CAGGGAGCAAGAAGAGAG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CCCATGCTTATGACCACGGT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6936395"/>
                  </a:ext>
                </a:extLst>
              </a:tr>
              <a:tr h="292591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2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28939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 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AGGGGAATTTGGCTGTGA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TACTTGCTCAGGGTCTTGGC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7626928"/>
                  </a:ext>
                </a:extLst>
              </a:tr>
              <a:tr h="292591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2r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28939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CATCGATCCGTTGATTTA 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TGCAACTGTTGGGATCAGAG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2514205"/>
                  </a:ext>
                </a:extLst>
              </a:tr>
              <a:tr h="258602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2rl1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28939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CTTTGCTCCTAGCAACCT  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CAGAGGGCGACAAGGTAGAG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2009797"/>
                  </a:ext>
                </a:extLst>
              </a:tr>
              <a:tr h="292591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krb1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28939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ATCAGTCAGGACCGCTAC  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GGACGACTTTGACGGAAC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2832732"/>
                  </a:ext>
                </a:extLst>
              </a:tr>
              <a:tr h="292591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krb2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GGGTGTTTGGAGAGGTGT 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GAGCATCAGGAAGCAGAT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0342153"/>
                  </a:ext>
                </a:extLst>
              </a:tr>
              <a:tr h="305250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gals3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28939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AAGTCCTGGTGAAGCTG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GCTGGTGAGGGTTATGTCAC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60558810"/>
                  </a:ext>
                </a:extLst>
              </a:tr>
              <a:tr h="305250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n2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28939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ATGGTGCACCCTGTGTCT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CCAGGCAAGTGCATTGGTAT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2146987"/>
                  </a:ext>
                </a:extLst>
              </a:tr>
              <a:tr h="305250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mgb1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28939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GGCGACTCTGTGCCTC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GCCTCTCGGCTTTTTAGGATC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625633"/>
                  </a:ext>
                </a:extLst>
              </a:tr>
              <a:tr h="305250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po</a:t>
                      </a:r>
                      <a:endParaRPr lang="en-US" sz="1200" i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AGCTAGTGGACAGAGCCTACAA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CACCGGCTGCTTGAAGTAAA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0559830"/>
                  </a:ext>
                </a:extLst>
              </a:tr>
              <a:tr h="305250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uman Gene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8730280"/>
                  </a:ext>
                </a:extLst>
              </a:tr>
              <a:tr h="319346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PDH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28939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AGGTGAAGGTCGGAGTC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GAAGATGGTGATGGGATTTC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4182816"/>
                  </a:ext>
                </a:extLst>
              </a:tr>
              <a:tr h="292591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2R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28939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TCCGGATATTTGACCAGCTC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CAGGATGAACACAACGATGG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1049946"/>
                  </a:ext>
                </a:extLst>
              </a:tr>
              <a:tr h="292591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2RL1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28939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TGGTAAGGTTGATGGCACA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CCAGTGAGGACAGATGCAGA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1419952"/>
                  </a:ext>
                </a:extLst>
              </a:tr>
              <a:tr h="300504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GALS3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TTCCACACTGTGCCCTTC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TGTAAATCCGGGGCTTGTAG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5007932"/>
                  </a:ext>
                </a:extLst>
              </a:tr>
              <a:tr h="305250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N2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CCCAGACCCAACTATGAT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TCTCTTCCAGGTCAGCTTCG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9200531"/>
                  </a:ext>
                </a:extLst>
              </a:tr>
              <a:tr h="305250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1B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-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GTGACTCGTGGGATGATG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-AGACAGCACGAGGCATTTTT-5’</a:t>
                      </a:r>
                    </a:p>
                  </a:txBody>
                  <a:tcPr marL="62630" marR="6263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0486286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2C79E7B-1E04-4676-9F45-526478E2E5A3}"/>
              </a:ext>
            </a:extLst>
          </p:cNvPr>
          <p:cNvSpPr txBox="1"/>
          <p:nvPr/>
        </p:nvSpPr>
        <p:spPr>
          <a:xfrm>
            <a:off x="743184" y="826148"/>
            <a:ext cx="5824030" cy="269304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150" b="1">
                <a:latin typeface="Times New Roman"/>
                <a:cs typeface="Times New Roman"/>
              </a:rPr>
              <a:t>Supplementary table 1: </a:t>
            </a:r>
            <a:r>
              <a:rPr lang="en-US" sz="1150">
                <a:latin typeface="Times New Roman"/>
                <a:cs typeface="Times New Roman"/>
              </a:rPr>
              <a:t>List of mouse and human primer sequence used in quantitative PCR</a:t>
            </a:r>
          </a:p>
        </p:txBody>
      </p:sp>
    </p:spTree>
    <p:extLst>
      <p:ext uri="{BB962C8B-B14F-4D97-AF65-F5344CB8AC3E}">
        <p14:creationId xmlns:p14="http://schemas.microsoft.com/office/powerpoint/2010/main" val="28193296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E1F7D094-23EB-4574-A541-43B7C2E2756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8491913"/>
              </p:ext>
            </p:extLst>
          </p:nvPr>
        </p:nvGraphicFramePr>
        <p:xfrm>
          <a:off x="678847" y="1061613"/>
          <a:ext cx="9750698" cy="4031073"/>
        </p:xfrm>
        <a:graphic>
          <a:graphicData uri="http://schemas.openxmlformats.org/drawingml/2006/table">
            <a:tbl>
              <a:tblPr/>
              <a:tblGrid>
                <a:gridCol w="1124482">
                  <a:extLst>
                    <a:ext uri="{9D8B030D-6E8A-4147-A177-3AD203B41FA5}">
                      <a16:colId xmlns:a16="http://schemas.microsoft.com/office/drawing/2014/main" val="1567569479"/>
                    </a:ext>
                  </a:extLst>
                </a:gridCol>
                <a:gridCol w="631566">
                  <a:extLst>
                    <a:ext uri="{9D8B030D-6E8A-4147-A177-3AD203B41FA5}">
                      <a16:colId xmlns:a16="http://schemas.microsoft.com/office/drawing/2014/main" val="2341384812"/>
                    </a:ext>
                  </a:extLst>
                </a:gridCol>
                <a:gridCol w="600745">
                  <a:extLst>
                    <a:ext uri="{9D8B030D-6E8A-4147-A177-3AD203B41FA5}">
                      <a16:colId xmlns:a16="http://schemas.microsoft.com/office/drawing/2014/main" val="117267573"/>
                    </a:ext>
                  </a:extLst>
                </a:gridCol>
                <a:gridCol w="477525">
                  <a:extLst>
                    <a:ext uri="{9D8B030D-6E8A-4147-A177-3AD203B41FA5}">
                      <a16:colId xmlns:a16="http://schemas.microsoft.com/office/drawing/2014/main" val="2606349061"/>
                    </a:ext>
                  </a:extLst>
                </a:gridCol>
                <a:gridCol w="492930">
                  <a:extLst>
                    <a:ext uri="{9D8B030D-6E8A-4147-A177-3AD203B41FA5}">
                      <a16:colId xmlns:a16="http://schemas.microsoft.com/office/drawing/2014/main" val="697078582"/>
                    </a:ext>
                  </a:extLst>
                </a:gridCol>
                <a:gridCol w="523741">
                  <a:extLst>
                    <a:ext uri="{9D8B030D-6E8A-4147-A177-3AD203B41FA5}">
                      <a16:colId xmlns:a16="http://schemas.microsoft.com/office/drawing/2014/main" val="2470431569"/>
                    </a:ext>
                  </a:extLst>
                </a:gridCol>
                <a:gridCol w="554533">
                  <a:extLst>
                    <a:ext uri="{9D8B030D-6E8A-4147-A177-3AD203B41FA5}">
                      <a16:colId xmlns:a16="http://schemas.microsoft.com/office/drawing/2014/main" val="2162692529"/>
                    </a:ext>
                  </a:extLst>
                </a:gridCol>
                <a:gridCol w="754801">
                  <a:extLst>
                    <a:ext uri="{9D8B030D-6E8A-4147-A177-3AD203B41FA5}">
                      <a16:colId xmlns:a16="http://schemas.microsoft.com/office/drawing/2014/main" val="3093708664"/>
                    </a:ext>
                  </a:extLst>
                </a:gridCol>
                <a:gridCol w="539137">
                  <a:extLst>
                    <a:ext uri="{9D8B030D-6E8A-4147-A177-3AD203B41FA5}">
                      <a16:colId xmlns:a16="http://schemas.microsoft.com/office/drawing/2014/main" val="2572346802"/>
                    </a:ext>
                  </a:extLst>
                </a:gridCol>
                <a:gridCol w="539137">
                  <a:extLst>
                    <a:ext uri="{9D8B030D-6E8A-4147-A177-3AD203B41FA5}">
                      <a16:colId xmlns:a16="http://schemas.microsoft.com/office/drawing/2014/main" val="1318111669"/>
                    </a:ext>
                  </a:extLst>
                </a:gridCol>
                <a:gridCol w="662377">
                  <a:extLst>
                    <a:ext uri="{9D8B030D-6E8A-4147-A177-3AD203B41FA5}">
                      <a16:colId xmlns:a16="http://schemas.microsoft.com/office/drawing/2014/main" val="1830355410"/>
                    </a:ext>
                  </a:extLst>
                </a:gridCol>
                <a:gridCol w="554533">
                  <a:extLst>
                    <a:ext uri="{9D8B030D-6E8A-4147-A177-3AD203B41FA5}">
                      <a16:colId xmlns:a16="http://schemas.microsoft.com/office/drawing/2014/main" val="2946979488"/>
                    </a:ext>
                  </a:extLst>
                </a:gridCol>
                <a:gridCol w="569946">
                  <a:extLst>
                    <a:ext uri="{9D8B030D-6E8A-4147-A177-3AD203B41FA5}">
                      <a16:colId xmlns:a16="http://schemas.microsoft.com/office/drawing/2014/main" val="183650"/>
                    </a:ext>
                  </a:extLst>
                </a:gridCol>
                <a:gridCol w="569946">
                  <a:extLst>
                    <a:ext uri="{9D8B030D-6E8A-4147-A177-3AD203B41FA5}">
                      <a16:colId xmlns:a16="http://schemas.microsoft.com/office/drawing/2014/main" val="1832626859"/>
                    </a:ext>
                  </a:extLst>
                </a:gridCol>
                <a:gridCol w="616162">
                  <a:extLst>
                    <a:ext uri="{9D8B030D-6E8A-4147-A177-3AD203B41FA5}">
                      <a16:colId xmlns:a16="http://schemas.microsoft.com/office/drawing/2014/main" val="3680980843"/>
                    </a:ext>
                  </a:extLst>
                </a:gridCol>
                <a:gridCol w="539137">
                  <a:extLst>
                    <a:ext uri="{9D8B030D-6E8A-4147-A177-3AD203B41FA5}">
                      <a16:colId xmlns:a16="http://schemas.microsoft.com/office/drawing/2014/main" val="1689016964"/>
                    </a:ext>
                  </a:extLst>
                </a:gridCol>
              </a:tblGrid>
              <a:tr h="379108">
                <a:tc>
                  <a:txBody>
                    <a:bodyPr/>
                    <a:lstStyle/>
                    <a:p>
                      <a:pPr algn="l" fontAlgn="t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ameters</a:t>
                      </a:r>
                    </a:p>
                  </a:txBody>
                  <a:tcPr marL="7910" marR="7910" marT="79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kb1</a:t>
                      </a:r>
                    </a:p>
                  </a:txBody>
                  <a:tcPr marL="7910" marR="7910" marT="79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ng1</a:t>
                      </a:r>
                    </a:p>
                  </a:txBody>
                  <a:tcPr marL="7910" marR="7910" marT="79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</a:t>
                      </a:r>
                    </a:p>
                  </a:txBody>
                  <a:tcPr marL="7910" marR="7910" marT="79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</a:t>
                      </a:r>
                    </a:p>
                  </a:txBody>
                  <a:tcPr marL="7910" marR="7910" marT="79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b</a:t>
                      </a:r>
                    </a:p>
                  </a:txBody>
                  <a:tcPr marL="7910" marR="7910" marT="79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a</a:t>
                      </a:r>
                      <a:endParaRPr 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10" marR="7910" marT="79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mgb1</a:t>
                      </a:r>
                    </a:p>
                  </a:txBody>
                  <a:tcPr marL="7910" marR="7910" marT="79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l2</a:t>
                      </a:r>
                    </a:p>
                  </a:txBody>
                  <a:tcPr marL="7910" marR="7910" marT="79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l3</a:t>
                      </a:r>
                    </a:p>
                  </a:txBody>
                  <a:tcPr marL="7910" marR="7910" marT="79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gre1</a:t>
                      </a:r>
                    </a:p>
                  </a:txBody>
                  <a:tcPr marL="7910" marR="7910" marT="79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</a:p>
                  </a:txBody>
                  <a:tcPr marL="7910" marR="7910" marT="79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g</a:t>
                      </a:r>
                    </a:p>
                  </a:txBody>
                  <a:tcPr marL="7910" marR="7910" marT="79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po</a:t>
                      </a:r>
                      <a:endParaRPr 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10" marR="7910" marT="79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als3</a:t>
                      </a:r>
                    </a:p>
                  </a:txBody>
                  <a:tcPr marL="7910" marR="7910" marT="79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2</a:t>
                      </a:r>
                    </a:p>
                  </a:txBody>
                  <a:tcPr marL="7910" marR="7910" marT="79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379099"/>
                  </a:ext>
                </a:extLst>
              </a:tr>
              <a:tr h="240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kb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4036966"/>
                  </a:ext>
                </a:extLst>
              </a:tr>
              <a:tr h="240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ng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898753"/>
                  </a:ext>
                </a:extLst>
              </a:tr>
              <a:tr h="28598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713764"/>
                  </a:ext>
                </a:extLst>
              </a:tr>
              <a:tr h="240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8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9064881"/>
                  </a:ext>
                </a:extLst>
              </a:tr>
              <a:tr h="240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b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1902313"/>
                  </a:ext>
                </a:extLst>
              </a:tr>
              <a:tr h="240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a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8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3943250"/>
                  </a:ext>
                </a:extLst>
              </a:tr>
              <a:tr h="240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mgb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4123874"/>
                  </a:ext>
                </a:extLst>
              </a:tr>
              <a:tr h="240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l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3034314"/>
                  </a:ext>
                </a:extLst>
              </a:tr>
              <a:tr h="240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l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1569823"/>
                  </a:ext>
                </a:extLst>
              </a:tr>
              <a:tr h="240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gre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9656512"/>
                  </a:ext>
                </a:extLst>
              </a:tr>
              <a:tr h="240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5022902"/>
                  </a:ext>
                </a:extLst>
              </a:tr>
              <a:tr h="240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g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3553628"/>
                  </a:ext>
                </a:extLst>
              </a:tr>
              <a:tr h="240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po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3206037"/>
                  </a:ext>
                </a:extLst>
              </a:tr>
              <a:tr h="240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als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515928"/>
                  </a:ext>
                </a:extLst>
              </a:tr>
              <a:tr h="240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2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7910" marR="7910" marT="79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1293392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79C03B05-7F27-4ED8-9484-35A6BE7CB297}"/>
              </a:ext>
            </a:extLst>
          </p:cNvPr>
          <p:cNvSpPr txBox="1"/>
          <p:nvPr/>
        </p:nvSpPr>
        <p:spPr>
          <a:xfrm>
            <a:off x="1" y="1061613"/>
            <a:ext cx="272361" cy="275021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191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9C03B05-7F27-4ED8-9484-35A6BE7CB297}"/>
              </a:ext>
            </a:extLst>
          </p:cNvPr>
          <p:cNvSpPr txBox="1"/>
          <p:nvPr/>
        </p:nvSpPr>
        <p:spPr>
          <a:xfrm>
            <a:off x="1" y="5634874"/>
            <a:ext cx="272361" cy="275021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191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C11DAD0B-AE6C-4BFD-9A8A-3746391906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13163311"/>
              </p:ext>
            </p:extLst>
          </p:nvPr>
        </p:nvGraphicFramePr>
        <p:xfrm>
          <a:off x="678847" y="5631210"/>
          <a:ext cx="10224816" cy="4875710"/>
        </p:xfrm>
        <a:graphic>
          <a:graphicData uri="http://schemas.openxmlformats.org/drawingml/2006/table">
            <a:tbl>
              <a:tblPr/>
              <a:tblGrid>
                <a:gridCol w="909926">
                  <a:extLst>
                    <a:ext uri="{9D8B030D-6E8A-4147-A177-3AD203B41FA5}">
                      <a16:colId xmlns:a16="http://schemas.microsoft.com/office/drawing/2014/main" val="3632722457"/>
                    </a:ext>
                  </a:extLst>
                </a:gridCol>
                <a:gridCol w="815075">
                  <a:extLst>
                    <a:ext uri="{9D8B030D-6E8A-4147-A177-3AD203B41FA5}">
                      <a16:colId xmlns:a16="http://schemas.microsoft.com/office/drawing/2014/main" val="3052402576"/>
                    </a:ext>
                  </a:extLst>
                </a:gridCol>
                <a:gridCol w="639919">
                  <a:extLst>
                    <a:ext uri="{9D8B030D-6E8A-4147-A177-3AD203B41FA5}">
                      <a16:colId xmlns:a16="http://schemas.microsoft.com/office/drawing/2014/main" val="844032903"/>
                    </a:ext>
                  </a:extLst>
                </a:gridCol>
                <a:gridCol w="486898">
                  <a:extLst>
                    <a:ext uri="{9D8B030D-6E8A-4147-A177-3AD203B41FA5}">
                      <a16:colId xmlns:a16="http://schemas.microsoft.com/office/drawing/2014/main" val="2636124458"/>
                    </a:ext>
                  </a:extLst>
                </a:gridCol>
                <a:gridCol w="445163">
                  <a:extLst>
                    <a:ext uri="{9D8B030D-6E8A-4147-A177-3AD203B41FA5}">
                      <a16:colId xmlns:a16="http://schemas.microsoft.com/office/drawing/2014/main" val="1848459527"/>
                    </a:ext>
                  </a:extLst>
                </a:gridCol>
                <a:gridCol w="556453">
                  <a:extLst>
                    <a:ext uri="{9D8B030D-6E8A-4147-A177-3AD203B41FA5}">
                      <a16:colId xmlns:a16="http://schemas.microsoft.com/office/drawing/2014/main" val="1486392189"/>
                    </a:ext>
                  </a:extLst>
                </a:gridCol>
                <a:gridCol w="612097">
                  <a:extLst>
                    <a:ext uri="{9D8B030D-6E8A-4147-A177-3AD203B41FA5}">
                      <a16:colId xmlns:a16="http://schemas.microsoft.com/office/drawing/2014/main" val="1886399315"/>
                    </a:ext>
                  </a:extLst>
                </a:gridCol>
                <a:gridCol w="806860">
                  <a:extLst>
                    <a:ext uri="{9D8B030D-6E8A-4147-A177-3AD203B41FA5}">
                      <a16:colId xmlns:a16="http://schemas.microsoft.com/office/drawing/2014/main" val="2703133710"/>
                    </a:ext>
                  </a:extLst>
                </a:gridCol>
                <a:gridCol w="570365">
                  <a:extLst>
                    <a:ext uri="{9D8B030D-6E8A-4147-A177-3AD203B41FA5}">
                      <a16:colId xmlns:a16="http://schemas.microsoft.com/office/drawing/2014/main" val="2682596386"/>
                    </a:ext>
                  </a:extLst>
                </a:gridCol>
                <a:gridCol w="570365">
                  <a:extLst>
                    <a:ext uri="{9D8B030D-6E8A-4147-A177-3AD203B41FA5}">
                      <a16:colId xmlns:a16="http://schemas.microsoft.com/office/drawing/2014/main" val="3879908337"/>
                    </a:ext>
                  </a:extLst>
                </a:gridCol>
                <a:gridCol w="723385">
                  <a:extLst>
                    <a:ext uri="{9D8B030D-6E8A-4147-A177-3AD203B41FA5}">
                      <a16:colId xmlns:a16="http://schemas.microsoft.com/office/drawing/2014/main" val="2766926414"/>
                    </a:ext>
                  </a:extLst>
                </a:gridCol>
                <a:gridCol w="584276">
                  <a:extLst>
                    <a:ext uri="{9D8B030D-6E8A-4147-A177-3AD203B41FA5}">
                      <a16:colId xmlns:a16="http://schemas.microsoft.com/office/drawing/2014/main" val="2982566236"/>
                    </a:ext>
                  </a:extLst>
                </a:gridCol>
                <a:gridCol w="612097">
                  <a:extLst>
                    <a:ext uri="{9D8B030D-6E8A-4147-A177-3AD203B41FA5}">
                      <a16:colId xmlns:a16="http://schemas.microsoft.com/office/drawing/2014/main" val="1958321865"/>
                    </a:ext>
                  </a:extLst>
                </a:gridCol>
                <a:gridCol w="612097">
                  <a:extLst>
                    <a:ext uri="{9D8B030D-6E8A-4147-A177-3AD203B41FA5}">
                      <a16:colId xmlns:a16="http://schemas.microsoft.com/office/drawing/2014/main" val="5394221"/>
                    </a:ext>
                  </a:extLst>
                </a:gridCol>
                <a:gridCol w="667743">
                  <a:extLst>
                    <a:ext uri="{9D8B030D-6E8A-4147-A177-3AD203B41FA5}">
                      <a16:colId xmlns:a16="http://schemas.microsoft.com/office/drawing/2014/main" val="659507210"/>
                    </a:ext>
                  </a:extLst>
                </a:gridCol>
                <a:gridCol w="612097">
                  <a:extLst>
                    <a:ext uri="{9D8B030D-6E8A-4147-A177-3AD203B41FA5}">
                      <a16:colId xmlns:a16="http://schemas.microsoft.com/office/drawing/2014/main" val="3685587715"/>
                    </a:ext>
                  </a:extLst>
                </a:gridCol>
              </a:tblGrid>
              <a:tr h="3710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ameters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kb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ng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b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a</a:t>
                      </a:r>
                      <a:endParaRPr 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mgb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l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l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gre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g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po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als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9687416"/>
                  </a:ext>
                </a:extLst>
              </a:tr>
              <a:tr h="30813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kb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6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2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7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933455"/>
                  </a:ext>
                </a:extLst>
              </a:tr>
              <a:tr h="30813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ng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9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7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8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6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8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2909522"/>
                  </a:ext>
                </a:extLst>
              </a:tr>
              <a:tr h="30813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4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9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6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9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2211977"/>
                  </a:ext>
                </a:extLst>
              </a:tr>
              <a:tr h="18948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5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9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5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7896032"/>
                  </a:ext>
                </a:extLst>
              </a:tr>
              <a:tr h="30813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b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4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7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4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7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4260559"/>
                  </a:ext>
                </a:extLst>
              </a:tr>
              <a:tr h="30813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a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6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4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4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5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6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7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7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49394542"/>
                  </a:ext>
                </a:extLst>
              </a:tr>
              <a:tr h="30813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mgb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9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5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5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9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6352582"/>
                  </a:ext>
                </a:extLst>
              </a:tr>
              <a:tr h="30813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l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7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7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0664596"/>
                  </a:ext>
                </a:extLst>
              </a:tr>
              <a:tr h="30813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l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6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7520663"/>
                  </a:ext>
                </a:extLst>
              </a:tr>
              <a:tr h="30813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gre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7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9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8996527"/>
                  </a:ext>
                </a:extLst>
              </a:tr>
              <a:tr h="30813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7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0666223"/>
                  </a:ext>
                </a:extLst>
              </a:tr>
              <a:tr h="30813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g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2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8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9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5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5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1288445"/>
                  </a:ext>
                </a:extLst>
              </a:tr>
              <a:tr h="30813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po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1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6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7587047"/>
                  </a:ext>
                </a:extLst>
              </a:tr>
              <a:tr h="30813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als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6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6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9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4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9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9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4344099"/>
                  </a:ext>
                </a:extLst>
              </a:tr>
              <a:tr h="30813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2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7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8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9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5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7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6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3578640"/>
                  </a:ext>
                </a:extLst>
              </a:tr>
            </a:tbl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1EE6B46D-C0DD-4894-8663-761BEE7E5BEB}"/>
              </a:ext>
            </a:extLst>
          </p:cNvPr>
          <p:cNvSpPr txBox="1"/>
          <p:nvPr/>
        </p:nvSpPr>
        <p:spPr>
          <a:xfrm>
            <a:off x="453936" y="11209523"/>
            <a:ext cx="11486039" cy="458368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1200" b="1">
                <a:latin typeface="Times New Roman"/>
                <a:ea typeface="Calibri" panose="020F0502020204030204" pitchFamily="34" charset="0"/>
                <a:cs typeface="Times New Roman"/>
              </a:rPr>
              <a:t>Supplementary figure 1: Correlation analysis of association between all the assessed genes after acute liver injury.</a:t>
            </a:r>
            <a:r>
              <a:rPr lang="en-US" sz="1200">
                <a:latin typeface="Times New Roman"/>
                <a:ea typeface="Calibri" panose="020F0502020204030204" pitchFamily="34" charset="0"/>
                <a:cs typeface="Times New Roman"/>
              </a:rPr>
              <a:t>  </a:t>
            </a:r>
          </a:p>
          <a:p>
            <a:r>
              <a:rPr lang="en-US" sz="1200">
                <a:latin typeface="Times New Roman"/>
                <a:ea typeface="Calibri" panose="020F0502020204030204" pitchFamily="34" charset="0"/>
                <a:cs typeface="Times New Roman"/>
              </a:rPr>
              <a:t>Tables showing </a:t>
            </a:r>
            <a:r>
              <a:rPr lang="en-US" sz="1200" i="1">
                <a:latin typeface="Times New Roman"/>
                <a:ea typeface="Calibri" panose="020F0502020204030204" pitchFamily="34" charset="0"/>
                <a:cs typeface="Times New Roman"/>
              </a:rPr>
              <a:t>r</a:t>
            </a:r>
            <a:r>
              <a:rPr lang="en-US" sz="1200">
                <a:latin typeface="Times New Roman"/>
                <a:ea typeface="Calibri" panose="020F0502020204030204" pitchFamily="34" charset="0"/>
                <a:cs typeface="Times New Roman"/>
              </a:rPr>
              <a:t> </a:t>
            </a:r>
            <a:r>
              <a:rPr lang="en-US" sz="1200" b="1">
                <a:latin typeface="Times New Roman"/>
                <a:ea typeface="Calibri" panose="020F0502020204030204" pitchFamily="34" charset="0"/>
                <a:cs typeface="Times New Roman"/>
              </a:rPr>
              <a:t>(A)</a:t>
            </a:r>
            <a:r>
              <a:rPr lang="en-US" sz="1200">
                <a:latin typeface="Times New Roman"/>
                <a:ea typeface="Calibri" panose="020F0502020204030204" pitchFamily="34" charset="0"/>
                <a:cs typeface="Times New Roman"/>
              </a:rPr>
              <a:t> and </a:t>
            </a:r>
            <a:r>
              <a:rPr lang="en-US" sz="1200" i="1">
                <a:latin typeface="Times New Roman"/>
                <a:ea typeface="Calibri" panose="020F0502020204030204" pitchFamily="34" charset="0"/>
                <a:cs typeface="Times New Roman"/>
              </a:rPr>
              <a:t>p</a:t>
            </a:r>
            <a:r>
              <a:rPr lang="en-US" sz="1200">
                <a:latin typeface="Times New Roman"/>
                <a:ea typeface="Calibri" panose="020F0502020204030204" pitchFamily="34" charset="0"/>
                <a:cs typeface="Times New Roman"/>
              </a:rPr>
              <a:t> </a:t>
            </a:r>
            <a:r>
              <a:rPr lang="en-US" sz="1200" b="1">
                <a:latin typeface="Times New Roman"/>
                <a:ea typeface="Calibri" panose="020F0502020204030204" pitchFamily="34" charset="0"/>
                <a:cs typeface="Times New Roman"/>
              </a:rPr>
              <a:t>(B)</a:t>
            </a:r>
            <a:r>
              <a:rPr lang="en-US" sz="1200">
                <a:latin typeface="Times New Roman"/>
                <a:ea typeface="Calibri" panose="020F0502020204030204" pitchFamily="34" charset="0"/>
                <a:cs typeface="Times New Roman"/>
              </a:rPr>
              <a:t> values of the correlation.</a:t>
            </a:r>
            <a:endParaRPr lang="en-US" sz="120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1629671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DD355D2-B87A-4C0F-9891-670C0712B6AD}"/>
              </a:ext>
            </a:extLst>
          </p:cNvPr>
          <p:cNvSpPr txBox="1"/>
          <p:nvPr/>
        </p:nvSpPr>
        <p:spPr>
          <a:xfrm>
            <a:off x="109072" y="969076"/>
            <a:ext cx="544722" cy="338554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40491E7-3EF2-4C39-93CC-43DC5547BF8C}"/>
              </a:ext>
            </a:extLst>
          </p:cNvPr>
          <p:cNvSpPr txBox="1"/>
          <p:nvPr/>
        </p:nvSpPr>
        <p:spPr>
          <a:xfrm>
            <a:off x="109072" y="3553453"/>
            <a:ext cx="544722" cy="338554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4E37633-C8AF-40D3-9D42-267759D8909B}"/>
              </a:ext>
            </a:extLst>
          </p:cNvPr>
          <p:cNvSpPr txBox="1"/>
          <p:nvPr/>
        </p:nvSpPr>
        <p:spPr>
          <a:xfrm rot="16200000">
            <a:off x="5326026" y="4549356"/>
            <a:ext cx="17353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% Necrotic Are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177337F-3EA9-4FBB-BCE0-5173B5D5B48E}"/>
              </a:ext>
            </a:extLst>
          </p:cNvPr>
          <p:cNvSpPr txBox="1"/>
          <p:nvPr/>
        </p:nvSpPr>
        <p:spPr>
          <a:xfrm>
            <a:off x="6440998" y="5716016"/>
            <a:ext cx="857335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Vehicl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15A2469-166F-4A30-91BC-14EE6A756851}"/>
              </a:ext>
            </a:extLst>
          </p:cNvPr>
          <p:cNvSpPr txBox="1"/>
          <p:nvPr/>
        </p:nvSpPr>
        <p:spPr>
          <a:xfrm>
            <a:off x="7141621" y="5724449"/>
            <a:ext cx="647875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CCl</a:t>
            </a:r>
            <a:r>
              <a:rPr lang="en-US" sz="1589" b="1" baseline="-2500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pic>
        <p:nvPicPr>
          <p:cNvPr id="10" name="Picture 9" descr="A picture containing ball, rug, shirt, playing&#10;&#10;Description automatically generated">
            <a:extLst>
              <a:ext uri="{FF2B5EF4-FFF2-40B4-BE49-F238E27FC236}">
                <a16:creationId xmlns:a16="http://schemas.microsoft.com/office/drawing/2014/main" id="{AE88342A-817A-4BD9-B260-AA5978E9CE3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5641" y="3920206"/>
            <a:ext cx="2515390" cy="1886567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91B31A2-69C6-4D93-AE03-F04E505BAD3C}"/>
              </a:ext>
            </a:extLst>
          </p:cNvPr>
          <p:cNvSpPr txBox="1"/>
          <p:nvPr/>
        </p:nvSpPr>
        <p:spPr>
          <a:xfrm>
            <a:off x="1547337" y="3592796"/>
            <a:ext cx="909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Vehicl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8FBE8A7-D611-4DCC-8BBC-C833CBA9A783}"/>
              </a:ext>
            </a:extLst>
          </p:cNvPr>
          <p:cNvSpPr txBox="1"/>
          <p:nvPr/>
        </p:nvSpPr>
        <p:spPr>
          <a:xfrm>
            <a:off x="4674836" y="3580593"/>
            <a:ext cx="7135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CCl</a:t>
            </a:r>
            <a:r>
              <a:rPr lang="en-US" sz="1600" b="1" baseline="-2500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A7D0628-2DA7-43FE-8A93-656F70345E76}"/>
              </a:ext>
            </a:extLst>
          </p:cNvPr>
          <p:cNvSpPr txBox="1"/>
          <p:nvPr/>
        </p:nvSpPr>
        <p:spPr>
          <a:xfrm>
            <a:off x="6248200" y="4039790"/>
            <a:ext cx="397171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D20C1EC-AE57-49BF-B7B2-C76EBE349AC7}"/>
              </a:ext>
            </a:extLst>
          </p:cNvPr>
          <p:cNvSpPr txBox="1"/>
          <p:nvPr/>
        </p:nvSpPr>
        <p:spPr>
          <a:xfrm>
            <a:off x="6246151" y="4540433"/>
            <a:ext cx="397171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62C016D-5303-487F-9C48-E970F1B71363}"/>
              </a:ext>
            </a:extLst>
          </p:cNvPr>
          <p:cNvSpPr txBox="1"/>
          <p:nvPr/>
        </p:nvSpPr>
        <p:spPr>
          <a:xfrm>
            <a:off x="6249877" y="5019053"/>
            <a:ext cx="397171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5680A2E-855C-4FE2-BADD-2CFFB47AF292}"/>
              </a:ext>
            </a:extLst>
          </p:cNvPr>
          <p:cNvSpPr txBox="1"/>
          <p:nvPr/>
        </p:nvSpPr>
        <p:spPr>
          <a:xfrm>
            <a:off x="6357736" y="5503930"/>
            <a:ext cx="297880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ABA7FA5-BEC2-488F-A0ED-3B68D90B4D33}"/>
              </a:ext>
            </a:extLst>
          </p:cNvPr>
          <p:cNvSpPr txBox="1"/>
          <p:nvPr/>
        </p:nvSpPr>
        <p:spPr>
          <a:xfrm>
            <a:off x="6246151" y="3543332"/>
            <a:ext cx="397171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CC32285E-6E39-4CD5-AC0D-5974B90BCB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00243" y="3456773"/>
            <a:ext cx="1241706" cy="2435744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20C958C6-2D6B-4A26-94F6-F782FE7A2D9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9669" y="3920207"/>
            <a:ext cx="2501911" cy="1876433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7D03960E-1C1A-47D2-AA55-7A42E9A78CB3}"/>
              </a:ext>
            </a:extLst>
          </p:cNvPr>
          <p:cNvSpPr txBox="1"/>
          <p:nvPr/>
        </p:nvSpPr>
        <p:spPr>
          <a:xfrm rot="16200000">
            <a:off x="5278843" y="1933007"/>
            <a:ext cx="198877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Collagen Deposition (% Stained Area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1C90C2F-D069-437F-B29D-D504B29BE98F}"/>
              </a:ext>
            </a:extLst>
          </p:cNvPr>
          <p:cNvSpPr txBox="1"/>
          <p:nvPr/>
        </p:nvSpPr>
        <p:spPr>
          <a:xfrm>
            <a:off x="1568827" y="1028715"/>
            <a:ext cx="9228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Vehicl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3D544CD-BB67-4830-AAB5-B5395FC9AE27}"/>
              </a:ext>
            </a:extLst>
          </p:cNvPr>
          <p:cNvSpPr txBox="1"/>
          <p:nvPr/>
        </p:nvSpPr>
        <p:spPr>
          <a:xfrm>
            <a:off x="4696324" y="1016512"/>
            <a:ext cx="6921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CCl</a:t>
            </a:r>
            <a:r>
              <a:rPr lang="en-US" sz="1600" b="1" baseline="-2500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F01FEAE-E4E7-490D-B616-A1431B375CE7}"/>
              </a:ext>
            </a:extLst>
          </p:cNvPr>
          <p:cNvSpPr txBox="1"/>
          <p:nvPr/>
        </p:nvSpPr>
        <p:spPr>
          <a:xfrm>
            <a:off x="6597796" y="3222575"/>
            <a:ext cx="941718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Vehicl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4AD35AA-C52F-41A9-B3A5-BEFC30063507}"/>
              </a:ext>
            </a:extLst>
          </p:cNvPr>
          <p:cNvSpPr txBox="1"/>
          <p:nvPr/>
        </p:nvSpPr>
        <p:spPr>
          <a:xfrm>
            <a:off x="7257969" y="3219781"/>
            <a:ext cx="655572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CCl</a:t>
            </a:r>
            <a:r>
              <a:rPr lang="en-US" sz="1589" b="1" baseline="-2500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91D7DB1-6625-428F-9EAE-367E304A0F80}"/>
              </a:ext>
            </a:extLst>
          </p:cNvPr>
          <p:cNvSpPr txBox="1"/>
          <p:nvPr/>
        </p:nvSpPr>
        <p:spPr>
          <a:xfrm>
            <a:off x="6434023" y="1030155"/>
            <a:ext cx="297880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5DB3AC9-37C7-4D64-A605-9D5CB9998838}"/>
              </a:ext>
            </a:extLst>
          </p:cNvPr>
          <p:cNvSpPr txBox="1"/>
          <p:nvPr/>
        </p:nvSpPr>
        <p:spPr>
          <a:xfrm>
            <a:off x="6434023" y="1687575"/>
            <a:ext cx="297880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3B72CCC-395C-40EA-B095-644B9BAF1FE9}"/>
              </a:ext>
            </a:extLst>
          </p:cNvPr>
          <p:cNvSpPr txBox="1"/>
          <p:nvPr/>
        </p:nvSpPr>
        <p:spPr>
          <a:xfrm>
            <a:off x="6446460" y="2357812"/>
            <a:ext cx="297880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45CB124-CF26-4244-AE61-C0075A29D288}"/>
              </a:ext>
            </a:extLst>
          </p:cNvPr>
          <p:cNvSpPr txBox="1"/>
          <p:nvPr/>
        </p:nvSpPr>
        <p:spPr>
          <a:xfrm>
            <a:off x="6446217" y="2990756"/>
            <a:ext cx="297880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pic>
        <p:nvPicPr>
          <p:cNvPr id="31" name="Picture 30" descr="A picture containing person, food, standing, person&#10;&#10;Description automatically generated">
            <a:extLst>
              <a:ext uri="{FF2B5EF4-FFF2-40B4-BE49-F238E27FC236}">
                <a16:creationId xmlns:a16="http://schemas.microsoft.com/office/drawing/2014/main" id="{68136F63-5E8D-4261-9335-7AE46E012D8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917" y="1360025"/>
            <a:ext cx="2513287" cy="1884989"/>
          </a:xfrm>
          <a:prstGeom prst="rect">
            <a:avLst/>
          </a:prstGeom>
        </p:spPr>
      </p:pic>
      <p:pic>
        <p:nvPicPr>
          <p:cNvPr id="32" name="Picture 31" descr="Map&#10;&#10;Description automatically generated">
            <a:extLst>
              <a:ext uri="{FF2B5EF4-FFF2-40B4-BE49-F238E27FC236}">
                <a16:creationId xmlns:a16="http://schemas.microsoft.com/office/drawing/2014/main" id="{924797EC-58AC-4EA0-9A50-667B3B5ABE22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3426" y="1363285"/>
            <a:ext cx="2513286" cy="1884988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42BD4E7F-9207-498A-9C59-EEFE18E1F1C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568269" y="936492"/>
            <a:ext cx="1530728" cy="2490537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E393A4E5-2580-4787-B75F-5EA8BDD45A85}"/>
              </a:ext>
            </a:extLst>
          </p:cNvPr>
          <p:cNvSpPr txBox="1"/>
          <p:nvPr/>
        </p:nvSpPr>
        <p:spPr>
          <a:xfrm>
            <a:off x="7267295" y="1330091"/>
            <a:ext cx="436931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097105A-FA9E-4678-9E84-7EB0215E15DC}"/>
              </a:ext>
            </a:extLst>
          </p:cNvPr>
          <p:cNvSpPr txBox="1"/>
          <p:nvPr/>
        </p:nvSpPr>
        <p:spPr>
          <a:xfrm>
            <a:off x="318389" y="9042749"/>
            <a:ext cx="8280953" cy="1754326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1200" b="1">
                <a:latin typeface="Times New Roman"/>
                <a:ea typeface="Calibri" panose="020F0502020204030204" pitchFamily="34" charset="0"/>
                <a:cs typeface="Times New Roman"/>
              </a:rPr>
              <a:t>Supplementary figure 2: Early fibrosis induction at 2.5 weeks. </a:t>
            </a:r>
            <a:r>
              <a:rPr lang="en-US" sz="1200">
                <a:latin typeface="Times New Roman"/>
                <a:cs typeface="Times New Roman"/>
              </a:rPr>
              <a:t>(</a:t>
            </a:r>
            <a:r>
              <a:rPr lang="en-US" sz="1200" b="1">
                <a:latin typeface="Times New Roman"/>
                <a:cs typeface="Times New Roman"/>
              </a:rPr>
              <a:t>A</a:t>
            </a:r>
            <a:r>
              <a:rPr lang="en-US" sz="1200">
                <a:latin typeface="Times New Roman"/>
                <a:cs typeface="Times New Roman"/>
              </a:rPr>
              <a:t>) </a:t>
            </a:r>
            <a:r>
              <a:rPr lang="en-US" sz="1200" i="1">
                <a:latin typeface="Times New Roman"/>
                <a:cs typeface="Times New Roman"/>
              </a:rPr>
              <a:t>Left</a:t>
            </a:r>
            <a:r>
              <a:rPr lang="en-US" sz="1200">
                <a:latin typeface="Times New Roman"/>
                <a:cs typeface="Times New Roman"/>
              </a:rPr>
              <a:t>, </a:t>
            </a:r>
            <a:r>
              <a:rPr lang="en-US" sz="1200" err="1">
                <a:latin typeface="Times New Roman"/>
                <a:cs typeface="Times New Roman"/>
              </a:rPr>
              <a:t>Picro</a:t>
            </a:r>
            <a:r>
              <a:rPr lang="en-US" sz="1200">
                <a:latin typeface="Times New Roman"/>
                <a:cs typeface="Times New Roman"/>
              </a:rPr>
              <a:t> Sirius red (PSR) (original magnification x40) staining of fibrotic area by collagen deposition from representative section of liver tissue after 2.5 weeks of CCl</a:t>
            </a:r>
            <a:r>
              <a:rPr lang="en-US" sz="1200" baseline="-25000">
                <a:latin typeface="Times New Roman"/>
                <a:cs typeface="Times New Roman"/>
              </a:rPr>
              <a:t>4</a:t>
            </a:r>
            <a:r>
              <a:rPr lang="en-US" sz="1200">
                <a:latin typeface="Times New Roman"/>
                <a:cs typeface="Times New Roman"/>
              </a:rPr>
              <a:t> injection. </a:t>
            </a:r>
            <a:r>
              <a:rPr lang="en-US" sz="1200" i="1">
                <a:latin typeface="Times New Roman"/>
                <a:cs typeface="Times New Roman"/>
              </a:rPr>
              <a:t>Right</a:t>
            </a:r>
            <a:r>
              <a:rPr lang="en-US" sz="1200">
                <a:latin typeface="Times New Roman"/>
                <a:cs typeface="Times New Roman"/>
              </a:rPr>
              <a:t>, quantification of collagen deposition by area fraction analysis using ImageJ tools (Data are represented as mean ± SEM, n = 5-6 mice per group). (</a:t>
            </a:r>
            <a:r>
              <a:rPr lang="en-US" sz="1200" b="1">
                <a:latin typeface="Times New Roman"/>
                <a:cs typeface="Times New Roman"/>
              </a:rPr>
              <a:t>B</a:t>
            </a:r>
            <a:r>
              <a:rPr lang="en-US" sz="1200">
                <a:latin typeface="Times New Roman"/>
                <a:cs typeface="Times New Roman"/>
              </a:rPr>
              <a:t>) </a:t>
            </a:r>
            <a:r>
              <a:rPr lang="en-US" sz="1200" i="1">
                <a:latin typeface="Times New Roman"/>
                <a:cs typeface="Times New Roman"/>
              </a:rPr>
              <a:t>Left</a:t>
            </a:r>
            <a:r>
              <a:rPr lang="en-US" sz="1200">
                <a:latin typeface="Times New Roman"/>
                <a:cs typeface="Times New Roman"/>
              </a:rPr>
              <a:t>, H&amp;E staining (original magnification x40) of necrotic area for extent of injury from representative section of liver tissue after 2.5 weeks of CCl</a:t>
            </a:r>
            <a:r>
              <a:rPr lang="en-US" sz="1200" baseline="-25000">
                <a:latin typeface="Times New Roman"/>
                <a:cs typeface="Times New Roman"/>
              </a:rPr>
              <a:t>4</a:t>
            </a:r>
            <a:r>
              <a:rPr lang="en-US" sz="1200">
                <a:latin typeface="Times New Roman"/>
                <a:cs typeface="Times New Roman"/>
              </a:rPr>
              <a:t> injection. </a:t>
            </a:r>
            <a:r>
              <a:rPr lang="en-US" sz="1200" i="1">
                <a:latin typeface="Times New Roman"/>
                <a:cs typeface="Times New Roman"/>
              </a:rPr>
              <a:t>Right</a:t>
            </a:r>
            <a:r>
              <a:rPr lang="en-US" sz="1200">
                <a:latin typeface="Times New Roman"/>
                <a:cs typeface="Times New Roman"/>
              </a:rPr>
              <a:t>, quantification of necrotic areas using ImageJ tools by morphometric analysis (Data are represented as mean ± SEM, n = 5-6 mice per group). </a:t>
            </a:r>
            <a:r>
              <a:rPr lang="pt-BR" sz="1200" err="1">
                <a:latin typeface="Times New Roman"/>
                <a:cs typeface="Times New Roman"/>
              </a:rPr>
              <a:t>Statistical</a:t>
            </a:r>
            <a:r>
              <a:rPr lang="pt-BR" sz="1200">
                <a:latin typeface="Times New Roman"/>
                <a:cs typeface="Times New Roman"/>
              </a:rPr>
              <a:t> </a:t>
            </a:r>
            <a:r>
              <a:rPr lang="pt-BR" sz="1200" err="1">
                <a:latin typeface="Times New Roman"/>
                <a:cs typeface="Times New Roman"/>
              </a:rPr>
              <a:t>significance</a:t>
            </a:r>
            <a:r>
              <a:rPr lang="pt-BR" sz="1200">
                <a:latin typeface="Times New Roman"/>
                <a:cs typeface="Times New Roman"/>
              </a:rPr>
              <a:t> </a:t>
            </a:r>
            <a:r>
              <a:rPr lang="pt-BR" sz="1200" err="1">
                <a:latin typeface="Times New Roman"/>
                <a:cs typeface="Times New Roman"/>
              </a:rPr>
              <a:t>was</a:t>
            </a:r>
            <a:r>
              <a:rPr lang="pt-BR" sz="1200">
                <a:latin typeface="Times New Roman"/>
                <a:cs typeface="Times New Roman"/>
              </a:rPr>
              <a:t> </a:t>
            </a:r>
            <a:r>
              <a:rPr lang="pt-BR" sz="1200" err="1">
                <a:latin typeface="Times New Roman"/>
                <a:cs typeface="Times New Roman"/>
              </a:rPr>
              <a:t>determined</a:t>
            </a:r>
            <a:r>
              <a:rPr lang="pt-BR" sz="1200">
                <a:latin typeface="Times New Roman"/>
                <a:cs typeface="Times New Roman"/>
              </a:rPr>
              <a:t> </a:t>
            </a:r>
            <a:r>
              <a:rPr lang="pt-BR" sz="1200" err="1">
                <a:latin typeface="Times New Roman"/>
                <a:cs typeface="Times New Roman"/>
              </a:rPr>
              <a:t>by</a:t>
            </a:r>
            <a:r>
              <a:rPr lang="pt-BR" sz="1200">
                <a:latin typeface="Times New Roman"/>
                <a:cs typeface="Times New Roman"/>
              </a:rPr>
              <a:t> Mann-Whitney </a:t>
            </a:r>
            <a:r>
              <a:rPr lang="pt-BR" sz="1200" err="1">
                <a:latin typeface="Times New Roman"/>
                <a:cs typeface="Times New Roman"/>
              </a:rPr>
              <a:t>test</a:t>
            </a:r>
            <a:r>
              <a:rPr lang="pt-BR" sz="1200">
                <a:latin typeface="Times New Roman"/>
                <a:cs typeface="Times New Roman"/>
              </a:rPr>
              <a:t> </a:t>
            </a:r>
            <a:r>
              <a:rPr lang="pt-BR" sz="1200" err="1">
                <a:latin typeface="Times New Roman"/>
                <a:cs typeface="Times New Roman"/>
              </a:rPr>
              <a:t>where</a:t>
            </a:r>
            <a:r>
              <a:rPr lang="pt-BR" sz="1200">
                <a:latin typeface="Times New Roman"/>
                <a:cs typeface="Times New Roman"/>
              </a:rPr>
              <a:t> **</a:t>
            </a:r>
            <a:r>
              <a:rPr lang="pt-BR" sz="1200" i="1">
                <a:latin typeface="Times New Roman"/>
                <a:cs typeface="Times New Roman"/>
              </a:rPr>
              <a:t>p &lt;</a:t>
            </a:r>
            <a:r>
              <a:rPr lang="pt-BR" sz="1200">
                <a:latin typeface="Times New Roman"/>
                <a:cs typeface="Times New Roman"/>
              </a:rPr>
              <a:t>0.005; ****</a:t>
            </a:r>
            <a:r>
              <a:rPr lang="pt-BR" sz="1200" i="1">
                <a:latin typeface="Times New Roman"/>
                <a:cs typeface="Times New Roman"/>
              </a:rPr>
              <a:t>p &lt;</a:t>
            </a:r>
            <a:r>
              <a:rPr lang="pt-BR" sz="1200">
                <a:latin typeface="Times New Roman"/>
                <a:cs typeface="Times New Roman"/>
              </a:rPr>
              <a:t>0.0001 (CCl4 versus </a:t>
            </a:r>
            <a:r>
              <a:rPr lang="pt-BR" sz="1200" err="1">
                <a:latin typeface="Times New Roman"/>
                <a:cs typeface="Times New Roman"/>
              </a:rPr>
              <a:t>Vehicle</a:t>
            </a:r>
            <a:r>
              <a:rPr lang="pt-BR" sz="1200">
                <a:latin typeface="Times New Roman"/>
                <a:cs typeface="Times New Roman"/>
              </a:rPr>
              <a:t>). </a:t>
            </a:r>
            <a:r>
              <a:rPr lang="en-US" sz="1200">
                <a:latin typeface="Times New Roman"/>
                <a:cs typeface="Times New Roman"/>
              </a:rPr>
              <a:t>(</a:t>
            </a:r>
            <a:r>
              <a:rPr lang="en-US" sz="1200" b="1">
                <a:latin typeface="Times New Roman"/>
                <a:cs typeface="Times New Roman"/>
              </a:rPr>
              <a:t>C</a:t>
            </a:r>
            <a:r>
              <a:rPr lang="en-US" sz="1200">
                <a:latin typeface="Times New Roman"/>
                <a:cs typeface="Times New Roman"/>
              </a:rPr>
              <a:t>) gene expression of Hmgb1 and </a:t>
            </a:r>
            <a:r>
              <a:rPr lang="en-US" sz="1200" err="1">
                <a:latin typeface="Times New Roman"/>
                <a:cs typeface="Times New Roman"/>
              </a:rPr>
              <a:t>Mpo</a:t>
            </a:r>
            <a:r>
              <a:rPr lang="en-US" sz="1200">
                <a:latin typeface="Times New Roman"/>
                <a:cs typeface="Times New Roman"/>
              </a:rPr>
              <a:t>. Data are represented as </a:t>
            </a:r>
            <a:r>
              <a:rPr lang="pt-BR" sz="1200" err="1">
                <a:latin typeface="Times New Roman"/>
                <a:cs typeface="Times New Roman"/>
              </a:rPr>
              <a:t>minimum</a:t>
            </a:r>
            <a:r>
              <a:rPr lang="pt-BR" sz="1200">
                <a:latin typeface="Times New Roman"/>
                <a:cs typeface="Times New Roman"/>
              </a:rPr>
              <a:t> </a:t>
            </a:r>
            <a:r>
              <a:rPr lang="pt-BR" sz="1200" err="1">
                <a:latin typeface="Times New Roman"/>
                <a:cs typeface="Times New Roman"/>
              </a:rPr>
              <a:t>to</a:t>
            </a:r>
            <a:r>
              <a:rPr lang="pt-BR" sz="1200">
                <a:latin typeface="Times New Roman"/>
                <a:cs typeface="Times New Roman"/>
              </a:rPr>
              <a:t> </a:t>
            </a:r>
            <a:r>
              <a:rPr lang="pt-BR" sz="1200" err="1">
                <a:latin typeface="Times New Roman"/>
                <a:cs typeface="Times New Roman"/>
              </a:rPr>
              <a:t>maximum</a:t>
            </a:r>
            <a:r>
              <a:rPr lang="pt-BR" sz="1200">
                <a:latin typeface="Times New Roman"/>
                <a:cs typeface="Times New Roman"/>
              </a:rPr>
              <a:t> </a:t>
            </a:r>
            <a:r>
              <a:rPr lang="pt-BR" sz="1200" err="1">
                <a:latin typeface="Times New Roman"/>
                <a:cs typeface="Times New Roman"/>
              </a:rPr>
              <a:t>values</a:t>
            </a:r>
            <a:r>
              <a:rPr lang="pt-BR" sz="1200">
                <a:latin typeface="Times New Roman"/>
                <a:cs typeface="Times New Roman"/>
              </a:rPr>
              <a:t> </a:t>
            </a:r>
            <a:r>
              <a:rPr lang="pt-BR" sz="1200" err="1">
                <a:latin typeface="Times New Roman"/>
                <a:cs typeface="Times New Roman"/>
              </a:rPr>
              <a:t>of</a:t>
            </a:r>
            <a:r>
              <a:rPr lang="pt-BR" sz="1200">
                <a:latin typeface="Times New Roman"/>
                <a:cs typeface="Times New Roman"/>
              </a:rPr>
              <a:t> </a:t>
            </a:r>
            <a:r>
              <a:rPr lang="pt-BR" sz="1200" err="1">
                <a:latin typeface="Times New Roman"/>
                <a:cs typeface="Times New Roman"/>
              </a:rPr>
              <a:t>boxplots</a:t>
            </a:r>
            <a:r>
              <a:rPr lang="en-US" sz="1200">
                <a:latin typeface="Times New Roman"/>
                <a:cs typeface="Times New Roman"/>
              </a:rPr>
              <a:t> with whiskers extending 1.5 times the interquartile range. Center lines indicate the medians while box limits represents the 25th and 75th percentiles. </a:t>
            </a:r>
            <a:r>
              <a:rPr lang="pt-BR" sz="1200">
                <a:latin typeface="Times New Roman"/>
                <a:cs typeface="Times New Roman"/>
              </a:rPr>
              <a:t> (n = 5-6 mice per </a:t>
            </a:r>
            <a:r>
              <a:rPr lang="pt-BR" sz="1200" err="1">
                <a:latin typeface="Times New Roman"/>
                <a:cs typeface="Times New Roman"/>
              </a:rPr>
              <a:t>group</a:t>
            </a:r>
            <a:r>
              <a:rPr lang="pt-BR" sz="1200">
                <a:latin typeface="Times New Roman"/>
                <a:cs typeface="Times New Roman"/>
              </a:rPr>
              <a:t>)</a:t>
            </a:r>
            <a:r>
              <a:rPr lang="en-US" sz="1200">
                <a:latin typeface="Times New Roman"/>
                <a:cs typeface="Times New Roman"/>
              </a:rPr>
              <a:t>. </a:t>
            </a:r>
            <a:endParaRPr lang="pt-BR" sz="1200">
              <a:latin typeface="Times New Roman"/>
              <a:cs typeface="Times New Roman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8B1336D-971E-4B79-B807-2EB3E4E3E1D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29488" y="6459762"/>
            <a:ext cx="1195362" cy="2186454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94DC8E54-8E58-4963-B2B6-EA152F6026A3}"/>
              </a:ext>
            </a:extLst>
          </p:cNvPr>
          <p:cNvSpPr txBox="1"/>
          <p:nvPr/>
        </p:nvSpPr>
        <p:spPr>
          <a:xfrm>
            <a:off x="1188447" y="7217359"/>
            <a:ext cx="258026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370EC00-55A8-4F91-AF48-1260B0A40D98}"/>
              </a:ext>
            </a:extLst>
          </p:cNvPr>
          <p:cNvSpPr txBox="1"/>
          <p:nvPr/>
        </p:nvSpPr>
        <p:spPr>
          <a:xfrm>
            <a:off x="1188447" y="7580640"/>
            <a:ext cx="258026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7299A38-1B76-491F-8237-C1E9938811F7}"/>
              </a:ext>
            </a:extLst>
          </p:cNvPr>
          <p:cNvSpPr txBox="1"/>
          <p:nvPr/>
        </p:nvSpPr>
        <p:spPr>
          <a:xfrm>
            <a:off x="1191676" y="7939935"/>
            <a:ext cx="258026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05DC28E-FD99-4CF6-A3A1-C784B813252E}"/>
              </a:ext>
            </a:extLst>
          </p:cNvPr>
          <p:cNvSpPr txBox="1"/>
          <p:nvPr/>
        </p:nvSpPr>
        <p:spPr>
          <a:xfrm>
            <a:off x="1199012" y="8293225"/>
            <a:ext cx="258026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4F3709C-8014-46BD-B253-34BC2ADF97C9}"/>
              </a:ext>
            </a:extLst>
          </p:cNvPr>
          <p:cNvSpPr txBox="1"/>
          <p:nvPr/>
        </p:nvSpPr>
        <p:spPr>
          <a:xfrm>
            <a:off x="1188449" y="6860180"/>
            <a:ext cx="258026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7BA0D68-D631-400A-BB12-9E89BFA395DA}"/>
              </a:ext>
            </a:extLst>
          </p:cNvPr>
          <p:cNvSpPr txBox="1"/>
          <p:nvPr/>
        </p:nvSpPr>
        <p:spPr>
          <a:xfrm>
            <a:off x="1188447" y="6512822"/>
            <a:ext cx="258026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B4239F7-0AB5-49A5-B2CB-8B0B4305AC36}"/>
              </a:ext>
            </a:extLst>
          </p:cNvPr>
          <p:cNvSpPr txBox="1"/>
          <p:nvPr/>
        </p:nvSpPr>
        <p:spPr>
          <a:xfrm>
            <a:off x="1568827" y="8519570"/>
            <a:ext cx="893734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Hmgb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95750DB-3818-460D-A5BC-01899A8C3EA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425561" y="6819025"/>
            <a:ext cx="1097010" cy="1823306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3B609137-F149-4C42-AF39-87E5BD346BD0}"/>
              </a:ext>
            </a:extLst>
          </p:cNvPr>
          <p:cNvSpPr txBox="1"/>
          <p:nvPr/>
        </p:nvSpPr>
        <p:spPr>
          <a:xfrm>
            <a:off x="2660394" y="8524106"/>
            <a:ext cx="619810" cy="338554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sz="1600" b="1" err="1">
                <a:latin typeface="Times New Roman" panose="02020603050405020304" pitchFamily="18" charset="0"/>
                <a:cs typeface="Times New Roman" panose="02020603050405020304" pitchFamily="18" charset="0"/>
              </a:rPr>
              <a:t>Mpo</a:t>
            </a:r>
            <a:endParaRPr 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FBDD7DA-8CFE-4C64-9D27-0561E2745F77}"/>
              </a:ext>
            </a:extLst>
          </p:cNvPr>
          <p:cNvSpPr txBox="1"/>
          <p:nvPr/>
        </p:nvSpPr>
        <p:spPr>
          <a:xfrm>
            <a:off x="109072" y="6385537"/>
            <a:ext cx="544722" cy="338554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0EC8EA5-3148-4D6C-A0AA-97D6D0C545BF}"/>
              </a:ext>
            </a:extLst>
          </p:cNvPr>
          <p:cNvSpPr txBox="1"/>
          <p:nvPr/>
        </p:nvSpPr>
        <p:spPr>
          <a:xfrm rot="16200000">
            <a:off x="-96860" y="7304188"/>
            <a:ext cx="2186454" cy="5201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Hepatic mRNA expression (fold over vehicle)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41F4067-992E-417F-9F75-2AE02AA79D57}"/>
              </a:ext>
            </a:extLst>
          </p:cNvPr>
          <p:cNvSpPr txBox="1"/>
          <p:nvPr/>
        </p:nvSpPr>
        <p:spPr>
          <a:xfrm>
            <a:off x="3690653" y="6703194"/>
            <a:ext cx="794324" cy="3055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90" b="1">
                <a:latin typeface="Times New Roman" panose="02020603050405020304" pitchFamily="18" charset="0"/>
                <a:cs typeface="Times New Roman" panose="02020603050405020304" pitchFamily="18" charset="0"/>
              </a:rPr>
              <a:t>Vehicle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AC83750-F03D-4476-9D3F-B275C305FB6D}"/>
              </a:ext>
            </a:extLst>
          </p:cNvPr>
          <p:cNvSpPr txBox="1"/>
          <p:nvPr/>
        </p:nvSpPr>
        <p:spPr>
          <a:xfrm>
            <a:off x="3728498" y="7035453"/>
            <a:ext cx="595743" cy="3055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90" b="1">
                <a:latin typeface="Times New Roman" panose="02020603050405020304" pitchFamily="18" charset="0"/>
                <a:cs typeface="Times New Roman" panose="02020603050405020304" pitchFamily="18" charset="0"/>
              </a:rPr>
              <a:t>CCl</a:t>
            </a:r>
            <a:r>
              <a:rPr lang="en-US" sz="1390" b="1" baseline="-2500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0CACC727-CA8F-436C-90E2-11A9C991DD13}"/>
              </a:ext>
            </a:extLst>
          </p:cNvPr>
          <p:cNvSpPr/>
          <p:nvPr/>
        </p:nvSpPr>
        <p:spPr>
          <a:xfrm>
            <a:off x="3542046" y="6782286"/>
            <a:ext cx="90787" cy="90787"/>
          </a:xfrm>
          <a:prstGeom prst="ellipse">
            <a:avLst/>
          </a:prstGeom>
          <a:solidFill>
            <a:srgbClr val="996600"/>
          </a:solidFill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9">
              <a:solidFill>
                <a:srgbClr val="996600"/>
              </a:solidFill>
            </a:endParaRPr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30B93639-8769-48A3-A7EC-977D85D9EB7B}"/>
              </a:ext>
            </a:extLst>
          </p:cNvPr>
          <p:cNvSpPr/>
          <p:nvPr/>
        </p:nvSpPr>
        <p:spPr>
          <a:xfrm>
            <a:off x="3548433" y="7149010"/>
            <a:ext cx="90787" cy="90787"/>
          </a:xfrm>
          <a:prstGeom prst="ellipse">
            <a:avLst/>
          </a:prstGeom>
        </p:spPr>
        <p:style>
          <a:lnRef idx="3">
            <a:schemeClr val="lt1"/>
          </a:lnRef>
          <a:fillRef idx="1">
            <a:schemeClr val="dk1"/>
          </a:fillRef>
          <a:effectRef idx="1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9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017F3558-115B-4067-8B62-5B281F663430}"/>
              </a:ext>
            </a:extLst>
          </p:cNvPr>
          <p:cNvSpPr txBox="1"/>
          <p:nvPr/>
        </p:nvSpPr>
        <p:spPr>
          <a:xfrm>
            <a:off x="7031184" y="3818371"/>
            <a:ext cx="642428" cy="3361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89" b="1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</a:p>
        </p:txBody>
      </p:sp>
    </p:spTree>
    <p:extLst>
      <p:ext uri="{BB962C8B-B14F-4D97-AF65-F5344CB8AC3E}">
        <p14:creationId xmlns:p14="http://schemas.microsoft.com/office/powerpoint/2010/main" val="29580725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4D82F7C-C609-47A5-AEDA-0200DABF29E0}"/>
              </a:ext>
            </a:extLst>
          </p:cNvPr>
          <p:cNvSpPr txBox="1"/>
          <p:nvPr/>
        </p:nvSpPr>
        <p:spPr>
          <a:xfrm>
            <a:off x="713662" y="7480020"/>
            <a:ext cx="8120166" cy="641715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1200" b="1">
                <a:latin typeface="Times New Roman"/>
                <a:ea typeface="Calibri" panose="020F0502020204030204" pitchFamily="34" charset="0"/>
                <a:cs typeface="Times New Roman"/>
              </a:rPr>
              <a:t>Supplementary figure 3: Correlation analysis showed association between receptors’ genes of PKSS and myofibroblast activators, and fibrotic areas:</a:t>
            </a:r>
            <a:r>
              <a:rPr lang="en-US" sz="1200">
                <a:latin typeface="Times New Roman"/>
                <a:ea typeface="Calibri" panose="020F0502020204030204" pitchFamily="34" charset="0"/>
                <a:cs typeface="Times New Roman"/>
              </a:rPr>
              <a:t> </a:t>
            </a:r>
            <a:r>
              <a:rPr lang="en-US" sz="1200">
                <a:latin typeface="Times New Roman"/>
                <a:cs typeface="Times New Roman"/>
              </a:rPr>
              <a:t>Heatmap showing correlation coefficients between the PKKS genes, and Lgals3, Ccn2 genes and fibrotic areas (FA) </a:t>
            </a:r>
            <a:r>
              <a:rPr lang="en-US" sz="1200" b="1">
                <a:latin typeface="Times New Roman"/>
                <a:cs typeface="Times New Roman"/>
              </a:rPr>
              <a:t>(A)</a:t>
            </a:r>
            <a:r>
              <a:rPr lang="en-US" sz="1200">
                <a:latin typeface="Times New Roman"/>
                <a:cs typeface="Times New Roman"/>
              </a:rPr>
              <a:t> 2.5 weeks </a:t>
            </a:r>
            <a:r>
              <a:rPr lang="en-US" sz="1200" b="1">
                <a:latin typeface="Times New Roman"/>
                <a:cs typeface="Times New Roman"/>
              </a:rPr>
              <a:t>(B) </a:t>
            </a:r>
            <a:r>
              <a:rPr lang="en-US" sz="1200">
                <a:latin typeface="Times New Roman"/>
                <a:cs typeface="Times New Roman"/>
              </a:rPr>
              <a:t>4 weeks </a:t>
            </a:r>
            <a:r>
              <a:rPr lang="en-US" sz="1200" b="1">
                <a:latin typeface="Times New Roman"/>
                <a:cs typeface="Times New Roman"/>
              </a:rPr>
              <a:t>(C)</a:t>
            </a:r>
            <a:r>
              <a:rPr lang="en-US" sz="1200">
                <a:latin typeface="Times New Roman"/>
                <a:cs typeface="Times New Roman"/>
              </a:rPr>
              <a:t> 6 weeks </a:t>
            </a:r>
            <a:r>
              <a:rPr lang="en-US" sz="1200" b="1">
                <a:latin typeface="Times New Roman"/>
                <a:cs typeface="Times New Roman"/>
              </a:rPr>
              <a:t>(D)</a:t>
            </a:r>
            <a:r>
              <a:rPr lang="en-US" sz="1200">
                <a:latin typeface="Times New Roman"/>
                <a:cs typeface="Times New Roman"/>
              </a:rPr>
              <a:t> 7 weeks. </a:t>
            </a:r>
            <a:endParaRPr 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09E0C383-33B3-4318-B148-6C2911EB1EA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8946" y="313329"/>
          <a:ext cx="4212116" cy="32843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85" name="Prism 8" r:id="rId3" imgW="4512027" imgH="3518625" progId="Prism8.Document">
                  <p:embed/>
                </p:oleObj>
              </mc:Choice>
              <mc:Fallback>
                <p:oleObj name="Prism 8" r:id="rId3" imgW="4512027" imgH="3518625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09E0C383-33B3-4318-B148-6C2911EB1E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8946" y="313329"/>
                        <a:ext cx="4212116" cy="3284324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77DAAC8A-989F-42B8-9849-CA5255D704C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41061" y="317768"/>
          <a:ext cx="4475160" cy="3585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86" name="Prism 8" r:id="rId5" imgW="4271218" imgH="3422515" progId="Prism8.Document">
                  <p:embed/>
                </p:oleObj>
              </mc:Choice>
              <mc:Fallback>
                <p:oleObj name="Prism 8" r:id="rId5" imgW="4271218" imgH="3422515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77DAAC8A-989F-42B8-9849-CA5255D704C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41061" y="317768"/>
                        <a:ext cx="4475160" cy="3585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3B75D2AB-BE85-4F67-9EC8-8F9B540BBD5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9804" y="3903446"/>
          <a:ext cx="4177521" cy="34117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87" name="Prism 8" r:id="rId7" imgW="3975695" imgH="3247214" progId="Prism8.Document">
                  <p:embed/>
                </p:oleObj>
              </mc:Choice>
              <mc:Fallback>
                <p:oleObj name="Prism 8" r:id="rId7" imgW="3975695" imgH="3247214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3B75D2AB-BE85-4F67-9EC8-8F9B540BBD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29804" y="3903446"/>
                        <a:ext cx="4177521" cy="34117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749C5F13-16F7-4A2F-B79F-D2C368E50A1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56803" y="3903446"/>
          <a:ext cx="4524903" cy="34117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88" name="Prism 8" r:id="rId9" imgW="3919182" imgH="3221297" progId="Prism8.Document">
                  <p:embed/>
                </p:oleObj>
              </mc:Choice>
              <mc:Fallback>
                <p:oleObj name="Prism 8" r:id="rId9" imgW="3919182" imgH="3221297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749C5F13-16F7-4A2F-B79F-D2C368E50A1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656803" y="3903446"/>
                        <a:ext cx="4524903" cy="34117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5CE3FE6F-A50D-43C5-AFEB-AC4446878AE1}"/>
              </a:ext>
            </a:extLst>
          </p:cNvPr>
          <p:cNvSpPr txBox="1"/>
          <p:nvPr/>
        </p:nvSpPr>
        <p:spPr>
          <a:xfrm>
            <a:off x="4457515" y="293499"/>
            <a:ext cx="299622" cy="275021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191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E155783-9F83-448C-98B3-E385BBE3F553}"/>
              </a:ext>
            </a:extLst>
          </p:cNvPr>
          <p:cNvSpPr txBox="1"/>
          <p:nvPr/>
        </p:nvSpPr>
        <p:spPr>
          <a:xfrm>
            <a:off x="4474123" y="3886759"/>
            <a:ext cx="299622" cy="275021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191" b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6413223-2D8B-495A-974C-FD777B180B50}"/>
              </a:ext>
            </a:extLst>
          </p:cNvPr>
          <p:cNvSpPr txBox="1"/>
          <p:nvPr/>
        </p:nvSpPr>
        <p:spPr>
          <a:xfrm>
            <a:off x="240576" y="295023"/>
            <a:ext cx="299622" cy="275021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191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B9D93A9-F489-4C97-A61D-E0665DD136EE}"/>
              </a:ext>
            </a:extLst>
          </p:cNvPr>
          <p:cNvSpPr txBox="1"/>
          <p:nvPr/>
        </p:nvSpPr>
        <p:spPr>
          <a:xfrm>
            <a:off x="240576" y="3889669"/>
            <a:ext cx="299622" cy="275021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191" b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1550636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7BCFD48-2B18-4908-825B-946D7EBAD04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4175263"/>
              </p:ext>
            </p:extLst>
          </p:nvPr>
        </p:nvGraphicFramePr>
        <p:xfrm>
          <a:off x="644836" y="795513"/>
          <a:ext cx="7956039" cy="2643738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077684">
                  <a:extLst>
                    <a:ext uri="{9D8B030D-6E8A-4147-A177-3AD203B41FA5}">
                      <a16:colId xmlns:a16="http://schemas.microsoft.com/office/drawing/2014/main" val="315663728"/>
                    </a:ext>
                  </a:extLst>
                </a:gridCol>
                <a:gridCol w="689717">
                  <a:extLst>
                    <a:ext uri="{9D8B030D-6E8A-4147-A177-3AD203B41FA5}">
                      <a16:colId xmlns:a16="http://schemas.microsoft.com/office/drawing/2014/main" val="2306862057"/>
                    </a:ext>
                  </a:extLst>
                </a:gridCol>
                <a:gridCol w="689717">
                  <a:extLst>
                    <a:ext uri="{9D8B030D-6E8A-4147-A177-3AD203B41FA5}">
                      <a16:colId xmlns:a16="http://schemas.microsoft.com/office/drawing/2014/main" val="1856599104"/>
                    </a:ext>
                  </a:extLst>
                </a:gridCol>
                <a:gridCol w="689717">
                  <a:extLst>
                    <a:ext uri="{9D8B030D-6E8A-4147-A177-3AD203B41FA5}">
                      <a16:colId xmlns:a16="http://schemas.microsoft.com/office/drawing/2014/main" val="1793396436"/>
                    </a:ext>
                  </a:extLst>
                </a:gridCol>
                <a:gridCol w="689717">
                  <a:extLst>
                    <a:ext uri="{9D8B030D-6E8A-4147-A177-3AD203B41FA5}">
                      <a16:colId xmlns:a16="http://schemas.microsoft.com/office/drawing/2014/main" val="1865752406"/>
                    </a:ext>
                  </a:extLst>
                </a:gridCol>
                <a:gridCol w="689717">
                  <a:extLst>
                    <a:ext uri="{9D8B030D-6E8A-4147-A177-3AD203B41FA5}">
                      <a16:colId xmlns:a16="http://schemas.microsoft.com/office/drawing/2014/main" val="115142277"/>
                    </a:ext>
                  </a:extLst>
                </a:gridCol>
                <a:gridCol w="689717">
                  <a:extLst>
                    <a:ext uri="{9D8B030D-6E8A-4147-A177-3AD203B41FA5}">
                      <a16:colId xmlns:a16="http://schemas.microsoft.com/office/drawing/2014/main" val="302427196"/>
                    </a:ext>
                  </a:extLst>
                </a:gridCol>
                <a:gridCol w="689717">
                  <a:extLst>
                    <a:ext uri="{9D8B030D-6E8A-4147-A177-3AD203B41FA5}">
                      <a16:colId xmlns:a16="http://schemas.microsoft.com/office/drawing/2014/main" val="4132650913"/>
                    </a:ext>
                  </a:extLst>
                </a:gridCol>
                <a:gridCol w="689717">
                  <a:extLst>
                    <a:ext uri="{9D8B030D-6E8A-4147-A177-3AD203B41FA5}">
                      <a16:colId xmlns:a16="http://schemas.microsoft.com/office/drawing/2014/main" val="1021112629"/>
                    </a:ext>
                  </a:extLst>
                </a:gridCol>
                <a:gridCol w="689717">
                  <a:extLst>
                    <a:ext uri="{9D8B030D-6E8A-4147-A177-3AD203B41FA5}">
                      <a16:colId xmlns:a16="http://schemas.microsoft.com/office/drawing/2014/main" val="3265411755"/>
                    </a:ext>
                  </a:extLst>
                </a:gridCol>
                <a:gridCol w="670902">
                  <a:extLst>
                    <a:ext uri="{9D8B030D-6E8A-4147-A177-3AD203B41FA5}">
                      <a16:colId xmlns:a16="http://schemas.microsoft.com/office/drawing/2014/main" val="1856220018"/>
                    </a:ext>
                  </a:extLst>
                </a:gridCol>
              </a:tblGrid>
              <a:tr h="31382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ameters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kb1 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ng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l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krb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krb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als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2150159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kb1 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5567118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ng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7084454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5699005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4437773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l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0925130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krb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2459305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krb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079099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als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877400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5988528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brotic area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0688190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8FA9C040-FB75-4EF4-86D5-78644BE5B1E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8499954"/>
              </p:ext>
            </p:extLst>
          </p:nvPr>
        </p:nvGraphicFramePr>
        <p:xfrm>
          <a:off x="660486" y="3778515"/>
          <a:ext cx="7908537" cy="2616617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115047">
                  <a:extLst>
                    <a:ext uri="{9D8B030D-6E8A-4147-A177-3AD203B41FA5}">
                      <a16:colId xmlns:a16="http://schemas.microsoft.com/office/drawing/2014/main" val="2017144143"/>
                    </a:ext>
                  </a:extLst>
                </a:gridCol>
                <a:gridCol w="686184">
                  <a:extLst>
                    <a:ext uri="{9D8B030D-6E8A-4147-A177-3AD203B41FA5}">
                      <a16:colId xmlns:a16="http://schemas.microsoft.com/office/drawing/2014/main" val="4219971260"/>
                    </a:ext>
                  </a:extLst>
                </a:gridCol>
                <a:gridCol w="686184">
                  <a:extLst>
                    <a:ext uri="{9D8B030D-6E8A-4147-A177-3AD203B41FA5}">
                      <a16:colId xmlns:a16="http://schemas.microsoft.com/office/drawing/2014/main" val="34821197"/>
                    </a:ext>
                  </a:extLst>
                </a:gridCol>
                <a:gridCol w="686184">
                  <a:extLst>
                    <a:ext uri="{9D8B030D-6E8A-4147-A177-3AD203B41FA5}">
                      <a16:colId xmlns:a16="http://schemas.microsoft.com/office/drawing/2014/main" val="4178631789"/>
                    </a:ext>
                  </a:extLst>
                </a:gridCol>
                <a:gridCol w="686184">
                  <a:extLst>
                    <a:ext uri="{9D8B030D-6E8A-4147-A177-3AD203B41FA5}">
                      <a16:colId xmlns:a16="http://schemas.microsoft.com/office/drawing/2014/main" val="2489799133"/>
                    </a:ext>
                  </a:extLst>
                </a:gridCol>
                <a:gridCol w="686184">
                  <a:extLst>
                    <a:ext uri="{9D8B030D-6E8A-4147-A177-3AD203B41FA5}">
                      <a16:colId xmlns:a16="http://schemas.microsoft.com/office/drawing/2014/main" val="1276706580"/>
                    </a:ext>
                  </a:extLst>
                </a:gridCol>
                <a:gridCol w="686184">
                  <a:extLst>
                    <a:ext uri="{9D8B030D-6E8A-4147-A177-3AD203B41FA5}">
                      <a16:colId xmlns:a16="http://schemas.microsoft.com/office/drawing/2014/main" val="1817930721"/>
                    </a:ext>
                  </a:extLst>
                </a:gridCol>
                <a:gridCol w="686184">
                  <a:extLst>
                    <a:ext uri="{9D8B030D-6E8A-4147-A177-3AD203B41FA5}">
                      <a16:colId xmlns:a16="http://schemas.microsoft.com/office/drawing/2014/main" val="553380485"/>
                    </a:ext>
                  </a:extLst>
                </a:gridCol>
                <a:gridCol w="686184">
                  <a:extLst>
                    <a:ext uri="{9D8B030D-6E8A-4147-A177-3AD203B41FA5}">
                      <a16:colId xmlns:a16="http://schemas.microsoft.com/office/drawing/2014/main" val="3685143847"/>
                    </a:ext>
                  </a:extLst>
                </a:gridCol>
                <a:gridCol w="686184">
                  <a:extLst>
                    <a:ext uri="{9D8B030D-6E8A-4147-A177-3AD203B41FA5}">
                      <a16:colId xmlns:a16="http://schemas.microsoft.com/office/drawing/2014/main" val="366678038"/>
                    </a:ext>
                  </a:extLst>
                </a:gridCol>
                <a:gridCol w="617834">
                  <a:extLst>
                    <a:ext uri="{9D8B030D-6E8A-4147-A177-3AD203B41FA5}">
                      <a16:colId xmlns:a16="http://schemas.microsoft.com/office/drawing/2014/main" val="2714489387"/>
                    </a:ext>
                  </a:extLst>
                </a:gridCol>
              </a:tblGrid>
              <a:tr h="28670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ameters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kb1 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ng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l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krb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krb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als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8227513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kb1 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1502464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ng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617929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5163322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9508171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l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2390808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krb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0553248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krb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5258901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als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0218776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4571506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3009378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39FA7BF5-6335-4389-B52D-368974871B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69388545"/>
              </p:ext>
            </p:extLst>
          </p:nvPr>
        </p:nvGraphicFramePr>
        <p:xfrm>
          <a:off x="658019" y="6718286"/>
          <a:ext cx="7911004" cy="2680378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009041">
                  <a:extLst>
                    <a:ext uri="{9D8B030D-6E8A-4147-A177-3AD203B41FA5}">
                      <a16:colId xmlns:a16="http://schemas.microsoft.com/office/drawing/2014/main" val="2529037348"/>
                    </a:ext>
                  </a:extLst>
                </a:gridCol>
                <a:gridCol w="625407">
                  <a:extLst>
                    <a:ext uri="{9D8B030D-6E8A-4147-A177-3AD203B41FA5}">
                      <a16:colId xmlns:a16="http://schemas.microsoft.com/office/drawing/2014/main" val="2209508387"/>
                    </a:ext>
                  </a:extLst>
                </a:gridCol>
                <a:gridCol w="661264">
                  <a:extLst>
                    <a:ext uri="{9D8B030D-6E8A-4147-A177-3AD203B41FA5}">
                      <a16:colId xmlns:a16="http://schemas.microsoft.com/office/drawing/2014/main" val="3706229471"/>
                    </a:ext>
                  </a:extLst>
                </a:gridCol>
                <a:gridCol w="648789">
                  <a:extLst>
                    <a:ext uri="{9D8B030D-6E8A-4147-A177-3AD203B41FA5}">
                      <a16:colId xmlns:a16="http://schemas.microsoft.com/office/drawing/2014/main" val="320737072"/>
                    </a:ext>
                  </a:extLst>
                </a:gridCol>
                <a:gridCol w="648789">
                  <a:extLst>
                    <a:ext uri="{9D8B030D-6E8A-4147-A177-3AD203B41FA5}">
                      <a16:colId xmlns:a16="http://schemas.microsoft.com/office/drawing/2014/main" val="650286614"/>
                    </a:ext>
                  </a:extLst>
                </a:gridCol>
                <a:gridCol w="648789">
                  <a:extLst>
                    <a:ext uri="{9D8B030D-6E8A-4147-A177-3AD203B41FA5}">
                      <a16:colId xmlns:a16="http://schemas.microsoft.com/office/drawing/2014/main" val="176640410"/>
                    </a:ext>
                  </a:extLst>
                </a:gridCol>
                <a:gridCol w="773556">
                  <a:extLst>
                    <a:ext uri="{9D8B030D-6E8A-4147-A177-3AD203B41FA5}">
                      <a16:colId xmlns:a16="http://schemas.microsoft.com/office/drawing/2014/main" val="1684981339"/>
                    </a:ext>
                  </a:extLst>
                </a:gridCol>
                <a:gridCol w="773556">
                  <a:extLst>
                    <a:ext uri="{9D8B030D-6E8A-4147-A177-3AD203B41FA5}">
                      <a16:colId xmlns:a16="http://schemas.microsoft.com/office/drawing/2014/main" val="3121917722"/>
                    </a:ext>
                  </a:extLst>
                </a:gridCol>
                <a:gridCol w="661264">
                  <a:extLst>
                    <a:ext uri="{9D8B030D-6E8A-4147-A177-3AD203B41FA5}">
                      <a16:colId xmlns:a16="http://schemas.microsoft.com/office/drawing/2014/main" val="3665485004"/>
                    </a:ext>
                  </a:extLst>
                </a:gridCol>
                <a:gridCol w="648789">
                  <a:extLst>
                    <a:ext uri="{9D8B030D-6E8A-4147-A177-3AD203B41FA5}">
                      <a16:colId xmlns:a16="http://schemas.microsoft.com/office/drawing/2014/main" val="59731805"/>
                    </a:ext>
                  </a:extLst>
                </a:gridCol>
                <a:gridCol w="811760">
                  <a:extLst>
                    <a:ext uri="{9D8B030D-6E8A-4147-A177-3AD203B41FA5}">
                      <a16:colId xmlns:a16="http://schemas.microsoft.com/office/drawing/2014/main" val="4096802357"/>
                    </a:ext>
                  </a:extLst>
                </a:gridCol>
              </a:tblGrid>
              <a:tr h="30550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ameters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kb1 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ng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l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krb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krb2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als3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2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8714546"/>
                  </a:ext>
                </a:extLst>
              </a:tr>
              <a:tr h="22939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kb1 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6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7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4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6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7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8598228"/>
                  </a:ext>
                </a:extLst>
              </a:tr>
              <a:tr h="22939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ng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6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9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1848507"/>
                  </a:ext>
                </a:extLst>
              </a:tr>
              <a:tr h="22939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2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6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9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2914653"/>
                  </a:ext>
                </a:extLst>
              </a:tr>
              <a:tr h="22939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7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0219373"/>
                  </a:ext>
                </a:extLst>
              </a:tr>
              <a:tr h="22939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l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4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2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0506995"/>
                  </a:ext>
                </a:extLst>
              </a:tr>
              <a:tr h="22939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krb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6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3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1057801"/>
                  </a:ext>
                </a:extLst>
              </a:tr>
              <a:tr h="22939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krb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0673752"/>
                  </a:ext>
                </a:extLst>
              </a:tr>
              <a:tr h="22939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als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4591127"/>
                  </a:ext>
                </a:extLst>
              </a:tr>
              <a:tr h="22939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7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6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1</a:t>
                      </a:r>
                    </a:p>
                  </a:txBody>
                  <a:tcPr marL="189845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1849790"/>
                  </a:ext>
                </a:extLst>
              </a:tr>
              <a:tr h="31031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</a:t>
                      </a:r>
                    </a:p>
                  </a:txBody>
                  <a:tcPr marL="7910" marR="7910" marT="7910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0</a:t>
                      </a:r>
                    </a:p>
                  </a:txBody>
                  <a:tcPr marL="189845" marR="7910" marT="7910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9</a:t>
                      </a:r>
                    </a:p>
                  </a:txBody>
                  <a:tcPr marL="189845" marR="7910" marT="7910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9</a:t>
                      </a:r>
                    </a:p>
                  </a:txBody>
                  <a:tcPr marL="189845" marR="7910" marT="7910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</a:t>
                      </a:r>
                    </a:p>
                  </a:txBody>
                  <a:tcPr marL="189845" marR="7910" marT="7910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189845" marR="7910" marT="7910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3</a:t>
                      </a:r>
                    </a:p>
                  </a:txBody>
                  <a:tcPr marL="189845" marR="7910" marT="7910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189845" marR="7910" marT="7910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189845" marR="7910" marT="7910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1</a:t>
                      </a:r>
                    </a:p>
                  </a:txBody>
                  <a:tcPr marL="189845" marR="7910" marT="7910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189845" marR="7910" marT="7910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4060084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9CEECBC8-4AA2-4562-9DFC-7E65F77DBABA}"/>
              </a:ext>
            </a:extLst>
          </p:cNvPr>
          <p:cNvSpPr txBox="1"/>
          <p:nvPr/>
        </p:nvSpPr>
        <p:spPr>
          <a:xfrm>
            <a:off x="71821" y="6572912"/>
            <a:ext cx="544722" cy="275021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191" b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9687F04-5661-498A-86C7-9CBE9572A6BE}"/>
              </a:ext>
            </a:extLst>
          </p:cNvPr>
          <p:cNvSpPr txBox="1"/>
          <p:nvPr/>
        </p:nvSpPr>
        <p:spPr>
          <a:xfrm>
            <a:off x="71821" y="659753"/>
            <a:ext cx="544722" cy="275021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191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6304FA6-BC12-45FD-A7F7-185810A09B77}"/>
              </a:ext>
            </a:extLst>
          </p:cNvPr>
          <p:cNvSpPr txBox="1"/>
          <p:nvPr/>
        </p:nvSpPr>
        <p:spPr>
          <a:xfrm>
            <a:off x="71821" y="3614342"/>
            <a:ext cx="453935" cy="275021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191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57AF7EA6-A6E9-4E40-BE2E-9A07506A6D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451291"/>
              </p:ext>
            </p:extLst>
          </p:nvPr>
        </p:nvGraphicFramePr>
        <p:xfrm>
          <a:off x="673997" y="9820176"/>
          <a:ext cx="7910955" cy="2652022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135776">
                  <a:extLst>
                    <a:ext uri="{9D8B030D-6E8A-4147-A177-3AD203B41FA5}">
                      <a16:colId xmlns:a16="http://schemas.microsoft.com/office/drawing/2014/main" val="753453364"/>
                    </a:ext>
                  </a:extLst>
                </a:gridCol>
                <a:gridCol w="681465">
                  <a:extLst>
                    <a:ext uri="{9D8B030D-6E8A-4147-A177-3AD203B41FA5}">
                      <a16:colId xmlns:a16="http://schemas.microsoft.com/office/drawing/2014/main" val="3716057902"/>
                    </a:ext>
                  </a:extLst>
                </a:gridCol>
                <a:gridCol w="681465">
                  <a:extLst>
                    <a:ext uri="{9D8B030D-6E8A-4147-A177-3AD203B41FA5}">
                      <a16:colId xmlns:a16="http://schemas.microsoft.com/office/drawing/2014/main" val="3976488464"/>
                    </a:ext>
                  </a:extLst>
                </a:gridCol>
                <a:gridCol w="681465">
                  <a:extLst>
                    <a:ext uri="{9D8B030D-6E8A-4147-A177-3AD203B41FA5}">
                      <a16:colId xmlns:a16="http://schemas.microsoft.com/office/drawing/2014/main" val="101401741"/>
                    </a:ext>
                  </a:extLst>
                </a:gridCol>
                <a:gridCol w="681465">
                  <a:extLst>
                    <a:ext uri="{9D8B030D-6E8A-4147-A177-3AD203B41FA5}">
                      <a16:colId xmlns:a16="http://schemas.microsoft.com/office/drawing/2014/main" val="3034514592"/>
                    </a:ext>
                  </a:extLst>
                </a:gridCol>
                <a:gridCol w="681465">
                  <a:extLst>
                    <a:ext uri="{9D8B030D-6E8A-4147-A177-3AD203B41FA5}">
                      <a16:colId xmlns:a16="http://schemas.microsoft.com/office/drawing/2014/main" val="946178107"/>
                    </a:ext>
                  </a:extLst>
                </a:gridCol>
                <a:gridCol w="681465">
                  <a:extLst>
                    <a:ext uri="{9D8B030D-6E8A-4147-A177-3AD203B41FA5}">
                      <a16:colId xmlns:a16="http://schemas.microsoft.com/office/drawing/2014/main" val="903388449"/>
                    </a:ext>
                  </a:extLst>
                </a:gridCol>
                <a:gridCol w="709859">
                  <a:extLst>
                    <a:ext uri="{9D8B030D-6E8A-4147-A177-3AD203B41FA5}">
                      <a16:colId xmlns:a16="http://schemas.microsoft.com/office/drawing/2014/main" val="2232263292"/>
                    </a:ext>
                  </a:extLst>
                </a:gridCol>
                <a:gridCol w="681465">
                  <a:extLst>
                    <a:ext uri="{9D8B030D-6E8A-4147-A177-3AD203B41FA5}">
                      <a16:colId xmlns:a16="http://schemas.microsoft.com/office/drawing/2014/main" val="1952662083"/>
                    </a:ext>
                  </a:extLst>
                </a:gridCol>
                <a:gridCol w="681465">
                  <a:extLst>
                    <a:ext uri="{9D8B030D-6E8A-4147-A177-3AD203B41FA5}">
                      <a16:colId xmlns:a16="http://schemas.microsoft.com/office/drawing/2014/main" val="1722983684"/>
                    </a:ext>
                  </a:extLst>
                </a:gridCol>
                <a:gridCol w="613600">
                  <a:extLst>
                    <a:ext uri="{9D8B030D-6E8A-4147-A177-3AD203B41FA5}">
                      <a16:colId xmlns:a16="http://schemas.microsoft.com/office/drawing/2014/main" val="1081636108"/>
                    </a:ext>
                  </a:extLst>
                </a:gridCol>
              </a:tblGrid>
              <a:tr h="3221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ameters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kb1 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ng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l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krb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krb2 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als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2350023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kb1 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3606440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ng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9377516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1768208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889010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rl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0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9445785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krb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70703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krb2 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112049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als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1962975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8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3077106"/>
                  </a:ext>
                </a:extLst>
              </a:tr>
              <a:tr h="23299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5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1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6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3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7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2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9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7910" marR="7910" marT="7910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0591935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8BA53104-C053-4451-BB18-6F6D2CE6EE80}"/>
              </a:ext>
            </a:extLst>
          </p:cNvPr>
          <p:cNvSpPr txBox="1"/>
          <p:nvPr/>
        </p:nvSpPr>
        <p:spPr>
          <a:xfrm>
            <a:off x="71821" y="9668927"/>
            <a:ext cx="544722" cy="275021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191" b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E8FE562-63F3-4A4F-A4B2-E24F47D5F0A7}"/>
              </a:ext>
            </a:extLst>
          </p:cNvPr>
          <p:cNvSpPr txBox="1"/>
          <p:nvPr/>
        </p:nvSpPr>
        <p:spPr>
          <a:xfrm>
            <a:off x="470259" y="12764944"/>
            <a:ext cx="8130617" cy="641715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1200" b="1">
                <a:latin typeface="Times New Roman"/>
                <a:ea typeface="Calibri" panose="020F0502020204030204" pitchFamily="34" charset="0"/>
                <a:cs typeface="Times New Roman"/>
              </a:rPr>
              <a:t>Supplementary figure 4: Correlation analysis showed association between receptors genes of PKSS and myofibroblast activators, and fibrotic areas.</a:t>
            </a:r>
            <a:r>
              <a:rPr lang="en-US" sz="1200">
                <a:latin typeface="Times New Roman"/>
                <a:ea typeface="Calibri" panose="020F0502020204030204" pitchFamily="34" charset="0"/>
                <a:cs typeface="Times New Roman"/>
              </a:rPr>
              <a:t> Table showing P values of correlation between the PKSS genes, and Lgals3, Ccn2 genes and fibrotic areas (FA) (</a:t>
            </a:r>
            <a:r>
              <a:rPr lang="en-US" sz="1200" b="1">
                <a:latin typeface="Times New Roman"/>
                <a:ea typeface="Calibri" panose="020F0502020204030204" pitchFamily="34" charset="0"/>
                <a:cs typeface="Times New Roman"/>
              </a:rPr>
              <a:t>A</a:t>
            </a:r>
            <a:r>
              <a:rPr lang="en-US" sz="1200">
                <a:latin typeface="Times New Roman"/>
                <a:ea typeface="Calibri" panose="020F0502020204030204" pitchFamily="34" charset="0"/>
                <a:cs typeface="Times New Roman"/>
              </a:rPr>
              <a:t>) 2.5 weeks (</a:t>
            </a:r>
            <a:r>
              <a:rPr lang="en-US" sz="1200" b="1">
                <a:latin typeface="Times New Roman"/>
                <a:ea typeface="Calibri" panose="020F0502020204030204" pitchFamily="34" charset="0"/>
                <a:cs typeface="Times New Roman"/>
              </a:rPr>
              <a:t>B</a:t>
            </a:r>
            <a:r>
              <a:rPr lang="en-US" sz="1200">
                <a:latin typeface="Times New Roman"/>
                <a:ea typeface="Calibri" panose="020F0502020204030204" pitchFamily="34" charset="0"/>
                <a:cs typeface="Times New Roman"/>
              </a:rPr>
              <a:t>) 4 weeks (</a:t>
            </a:r>
            <a:r>
              <a:rPr lang="en-US" sz="1200" b="1">
                <a:latin typeface="Times New Roman"/>
                <a:ea typeface="Calibri" panose="020F0502020204030204" pitchFamily="34" charset="0"/>
                <a:cs typeface="Times New Roman"/>
              </a:rPr>
              <a:t>C</a:t>
            </a:r>
            <a:r>
              <a:rPr lang="en-US" sz="1200">
                <a:latin typeface="Times New Roman"/>
                <a:ea typeface="Calibri" panose="020F0502020204030204" pitchFamily="34" charset="0"/>
                <a:cs typeface="Times New Roman"/>
              </a:rPr>
              <a:t>) 6 weeks (</a:t>
            </a:r>
            <a:r>
              <a:rPr lang="en-US" sz="1200" b="1">
                <a:latin typeface="Times New Roman"/>
                <a:ea typeface="Calibri" panose="020F0502020204030204" pitchFamily="34" charset="0"/>
                <a:cs typeface="Times New Roman"/>
              </a:rPr>
              <a:t>D</a:t>
            </a:r>
            <a:r>
              <a:rPr lang="en-US" sz="1200">
                <a:latin typeface="Times New Roman"/>
                <a:ea typeface="Calibri" panose="020F0502020204030204" pitchFamily="34" charset="0"/>
                <a:cs typeface="Times New Roman"/>
              </a:rPr>
              <a:t>) 7 weeks . </a:t>
            </a:r>
            <a:endParaRPr 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27212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Application>Microsoft Office PowerPoint</Application>
  <PresentationFormat>Custom</PresentationFormat>
  <Slides>5</Slides>
  <Notes>0</Notes>
  <HiddenSlides>0</HiddenSlide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brahim ahmed</dc:creator>
  <cp:revision>1</cp:revision>
  <dcterms:created xsi:type="dcterms:W3CDTF">2021-05-09T11:05:25Z</dcterms:created>
  <dcterms:modified xsi:type="dcterms:W3CDTF">2021-07-18T06:55:26Z</dcterms:modified>
</cp:coreProperties>
</file>